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68" r:id="rId4"/>
    <p:sldId id="266" r:id="rId5"/>
    <p:sldId id="261" r:id="rId6"/>
    <p:sldId id="258" r:id="rId7"/>
    <p:sldId id="259" r:id="rId8"/>
    <p:sldId id="260" r:id="rId9"/>
    <p:sldId id="262" r:id="rId10"/>
    <p:sldId id="267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 xmlns:mv="urn:schemas-microsoft-com:mac:vml" xmlns:mc="http://schemas.openxmlformats.org/markup-compatibility/2006">
        <p15:guide id="1" orient="horz" pos="2160">
          <p15:clr>
            <a:srgbClr val="A4A3A4"/>
          </p15:clr>
        </p15:guide>
        <p15:guide id="2" pos="29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12" y="-288"/>
      </p:cViewPr>
      <p:guideLst>
        <p:guide orient="horz" pos="2160"/>
        <p:guide pos="29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printerSettings" Target="printerSettings/printerSettings1.bin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SL:Documents:Nuclear:TID:Curr:TID_MA%20Outcom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DSL:Documents:Nuclear:TID:Curr:TID_MA%20Outcom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E$5</c:f>
              <c:strCache>
                <c:ptCount val="1"/>
                <c:pt idx="0">
                  <c:v>TID present</c:v>
                </c:pt>
              </c:strCache>
            </c:strRef>
          </c:tx>
          <c:invertIfNegative val="0"/>
          <c:val>
            <c:numRef>
              <c:f>Sheet2!$E$6:$E$8</c:f>
              <c:numCache>
                <c:formatCode>0.00%</c:formatCode>
                <c:ptCount val="3"/>
                <c:pt idx="0">
                  <c:v>0.059</c:v>
                </c:pt>
                <c:pt idx="1">
                  <c:v>0.054</c:v>
                </c:pt>
                <c:pt idx="2">
                  <c:v>0.072</c:v>
                </c:pt>
              </c:numCache>
            </c:numRef>
          </c:val>
        </c:ser>
        <c:ser>
          <c:idx val="1"/>
          <c:order val="1"/>
          <c:tx>
            <c:strRef>
              <c:f>Sheet2!$F$5</c:f>
              <c:strCache>
                <c:ptCount val="1"/>
                <c:pt idx="0">
                  <c:v>No TID</c:v>
                </c:pt>
              </c:strCache>
            </c:strRef>
          </c:tx>
          <c:invertIfNegative val="0"/>
          <c:val>
            <c:numRef>
              <c:f>Sheet2!$F$6:$F$8</c:f>
              <c:numCache>
                <c:formatCode>0.00%</c:formatCode>
                <c:ptCount val="3"/>
                <c:pt idx="0">
                  <c:v>0.002</c:v>
                </c:pt>
                <c:pt idx="1">
                  <c:v>0.019</c:v>
                </c:pt>
                <c:pt idx="2">
                  <c:v>0.0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4851720"/>
        <c:axId val="2134804152"/>
      </c:barChart>
      <c:catAx>
        <c:axId val="2134851720"/>
        <c:scaling>
          <c:orientation val="minMax"/>
        </c:scaling>
        <c:delete val="0"/>
        <c:axPos val="b"/>
        <c:majorTickMark val="out"/>
        <c:minorTickMark val="none"/>
        <c:tickLblPos val="none"/>
        <c:crossAx val="2134804152"/>
        <c:crosses val="autoZero"/>
        <c:auto val="1"/>
        <c:lblAlgn val="ctr"/>
        <c:lblOffset val="100"/>
        <c:noMultiLvlLbl val="0"/>
      </c:catAx>
      <c:valAx>
        <c:axId val="2134804152"/>
        <c:scaling>
          <c:orientation val="minMax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2134851720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147848681954496"/>
          <c:y val="0.0132865683565905"/>
          <c:w val="0.535604768153981"/>
          <c:h val="0.0745857923387669"/>
        </c:manualLayout>
      </c:layout>
      <c:overlay val="0"/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4</c:f>
              <c:strCache>
                <c:ptCount val="1"/>
                <c:pt idx="0">
                  <c:v>TID present</c:v>
                </c:pt>
              </c:strCache>
            </c:strRef>
          </c:tx>
          <c:invertIfNegative val="0"/>
          <c:val>
            <c:numRef>
              <c:f>Sheet2!$B$5:$B$7</c:f>
              <c:numCache>
                <c:formatCode>0.00%</c:formatCode>
                <c:ptCount val="3"/>
                <c:pt idx="0" formatCode="0.0%">
                  <c:v>0.024</c:v>
                </c:pt>
                <c:pt idx="1">
                  <c:v>0.024</c:v>
                </c:pt>
                <c:pt idx="2">
                  <c:v>0.049</c:v>
                </c:pt>
              </c:numCache>
            </c:numRef>
          </c:val>
        </c:ser>
        <c:ser>
          <c:idx val="1"/>
          <c:order val="1"/>
          <c:tx>
            <c:strRef>
              <c:f>Sheet2!$C$4</c:f>
              <c:strCache>
                <c:ptCount val="1"/>
                <c:pt idx="0">
                  <c:v>No TID</c:v>
                </c:pt>
              </c:strCache>
            </c:strRef>
          </c:tx>
          <c:invertIfNegative val="0"/>
          <c:val>
            <c:numRef>
              <c:f>Sheet2!$C$5:$C$7</c:f>
              <c:numCache>
                <c:formatCode>0.00%</c:formatCode>
                <c:ptCount val="3"/>
                <c:pt idx="0" formatCode="0.0%">
                  <c:v>0.006</c:v>
                </c:pt>
                <c:pt idx="1">
                  <c:v>0.004</c:v>
                </c:pt>
                <c:pt idx="2">
                  <c:v>0.00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3912776"/>
        <c:axId val="2133915752"/>
      </c:barChart>
      <c:catAx>
        <c:axId val="2133912776"/>
        <c:scaling>
          <c:orientation val="minMax"/>
        </c:scaling>
        <c:delete val="0"/>
        <c:axPos val="b"/>
        <c:majorTickMark val="out"/>
        <c:minorTickMark val="none"/>
        <c:tickLblPos val="none"/>
        <c:crossAx val="2133915752"/>
        <c:crosses val="autoZero"/>
        <c:auto val="0"/>
        <c:lblAlgn val="ctr"/>
        <c:lblOffset val="100"/>
        <c:noMultiLvlLbl val="0"/>
      </c:catAx>
      <c:valAx>
        <c:axId val="2133915752"/>
        <c:scaling>
          <c:orientation val="minMax"/>
          <c:max val="0.08"/>
        </c:scaling>
        <c:delete val="0"/>
        <c:axPos val="l"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1400" baseline="0"/>
            </a:pPr>
            <a:endParaRPr lang="en-US"/>
          </a:p>
        </c:txPr>
        <c:crossAx val="2133912776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142588156880715"/>
          <c:y val="0.0122764652243786"/>
          <c:w val="0.505049323064157"/>
          <c:h val="0.0713847499002221"/>
        </c:manualLayout>
      </c:layout>
      <c:overlay val="0"/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2781828-0ECD-469D-9422-B32915E19CD7}" type="doc">
      <dgm:prSet loTypeId="urn:microsoft.com/office/officeart/2005/8/layout/hierarchy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C0EA6C79-EE6E-4B4B-8E49-F9863A2E9915}">
      <dgm:prSet custT="1"/>
      <dgm:spPr>
        <a:xfrm>
          <a:off x="3724708" y="1221859"/>
          <a:ext cx="2068266" cy="388197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5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records screened for relevance</a:t>
          </a:r>
          <a:endParaRPr lang="en-US" sz="105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BD0F97D6-CDA8-46CD-95EB-5C60EBC0A9A5}" type="parTrans" cxnId="{F5CCF018-9463-475C-AAD1-F02534E6CAED}">
      <dgm:prSet/>
      <dgm:spPr>
        <a:xfrm>
          <a:off x="4614873" y="959236"/>
          <a:ext cx="91440" cy="169286"/>
        </a:xfrm>
        <a:custGeom>
          <a:avLst/>
          <a:gdLst/>
          <a:ahLst/>
          <a:cxnLst/>
          <a:rect l="0" t="0" r="0" b="0"/>
          <a:pathLst>
            <a:path>
              <a:moveTo>
                <a:pt x="77375" y="0"/>
              </a:moveTo>
              <a:lnTo>
                <a:pt x="77375" y="87372"/>
              </a:lnTo>
              <a:lnTo>
                <a:pt x="45720" y="87372"/>
              </a:lnTo>
              <a:lnTo>
                <a:pt x="45720" y="169286"/>
              </a:lnTo>
            </a:path>
          </a:pathLst>
        </a:custGeom>
        <a:noFill/>
        <a:ln w="19050" cap="flat" cmpd="sng" algn="ctr">
          <a:solidFill>
            <a:srgbClr val="94B6D2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 sz="1400"/>
        </a:p>
      </dgm:t>
    </dgm:pt>
    <dgm:pt modelId="{F985F4C3-34FC-47D4-B157-49FE16D488BD}" type="sibTrans" cxnId="{F5CCF018-9463-475C-AAD1-F02534E6CAED}">
      <dgm:prSet/>
      <dgm:spPr/>
      <dgm:t>
        <a:bodyPr/>
        <a:lstStyle/>
        <a:p>
          <a:endParaRPr lang="en-US" sz="1400"/>
        </a:p>
      </dgm:t>
    </dgm:pt>
    <dgm:pt modelId="{38EF6A01-FEB9-4048-8C52-26B04E0AF816}">
      <dgm:prSet custT="1"/>
      <dgm:spPr>
        <a:xfrm>
          <a:off x="1461007" y="1944046"/>
          <a:ext cx="3971729" cy="523124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51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full text articles assessed for eligibility by 2 independent reviewers (MA &amp; HE)</a:t>
          </a:r>
        </a:p>
        <a:p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A third investigator resolved any conflicts (DL)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F11A3039-FC49-4D21-8AA5-C7B311F8F1A1}" type="parTrans" cxnId="{AA4610B9-5C77-4C1F-90A4-6DDAA61E8B46}">
      <dgm:prSet/>
      <dgm:spPr>
        <a:xfrm>
          <a:off x="3348623" y="1516720"/>
          <a:ext cx="1311970" cy="333988"/>
        </a:xfrm>
        <a:custGeom>
          <a:avLst/>
          <a:gdLst/>
          <a:ahLst/>
          <a:cxnLst/>
          <a:rect l="0" t="0" r="0" b="0"/>
          <a:pathLst>
            <a:path>
              <a:moveTo>
                <a:pt x="885561" y="0"/>
              </a:moveTo>
              <a:lnTo>
                <a:pt x="885561" y="248203"/>
              </a:lnTo>
              <a:lnTo>
                <a:pt x="0" y="248203"/>
              </a:lnTo>
              <a:lnTo>
                <a:pt x="0" y="364216"/>
              </a:lnTo>
            </a:path>
          </a:pathLst>
        </a:custGeom>
        <a:noFill/>
        <a:ln w="19050" cap="flat" cmpd="sng" algn="ctr">
          <a:solidFill>
            <a:srgbClr val="94B6D2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 sz="1400"/>
        </a:p>
      </dgm:t>
    </dgm:pt>
    <dgm:pt modelId="{30A8F76A-B0D0-4546-AC7E-A9BAB539C623}" type="sibTrans" cxnId="{AA4610B9-5C77-4C1F-90A4-6DDAA61E8B46}">
      <dgm:prSet/>
      <dgm:spPr/>
      <dgm:t>
        <a:bodyPr/>
        <a:lstStyle/>
        <a:p>
          <a:endParaRPr lang="en-US" sz="1400"/>
        </a:p>
      </dgm:t>
    </dgm:pt>
    <dgm:pt modelId="{3DE79F65-FA52-4CBA-A0DF-5A79F8DEDA72}">
      <dgm:prSet custT="1"/>
      <dgm:spPr>
        <a:xfrm>
          <a:off x="6200627" y="1885364"/>
          <a:ext cx="1045168" cy="538963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pPr algn="l"/>
          <a:endParaRPr lang="en-US" sz="14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algn="l"/>
          <a:endParaRPr lang="en-US" sz="14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algn="ctr"/>
          <a:endParaRPr lang="en-US" sz="10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algn="ctr"/>
          <a:r>
            <a:rPr lang="en-US" sz="100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317 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records excluded</a:t>
          </a:r>
        </a:p>
        <a:p>
          <a:pPr algn="l"/>
          <a:endParaRPr lang="en-US" sz="14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algn="l"/>
          <a:endParaRPr lang="en-US" sz="14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algn="ctr"/>
          <a:endParaRPr lang="en-US" sz="14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DBA6DA10-6740-4941-AE30-C0073B6C8D12}" type="parTrans" cxnId="{C837C12D-D54B-4485-8A46-CCFA9E7325D1}">
      <dgm:prSet/>
      <dgm:spPr>
        <a:xfrm>
          <a:off x="4660593" y="1516720"/>
          <a:ext cx="1964369" cy="27530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48203"/>
              </a:lnTo>
              <a:lnTo>
                <a:pt x="2087195" y="248203"/>
              </a:lnTo>
              <a:lnTo>
                <a:pt x="2087195" y="364216"/>
              </a:lnTo>
            </a:path>
          </a:pathLst>
        </a:custGeom>
        <a:noFill/>
        <a:ln w="19050" cap="flat" cmpd="sng" algn="ctr">
          <a:solidFill>
            <a:srgbClr val="94B6D2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 sz="1400"/>
        </a:p>
      </dgm:t>
    </dgm:pt>
    <dgm:pt modelId="{0E0A74D6-C7F7-47C8-B310-9F2383AD854D}" type="sibTrans" cxnId="{C837C12D-D54B-4485-8A46-CCFA9E7325D1}">
      <dgm:prSet/>
      <dgm:spPr/>
      <dgm:t>
        <a:bodyPr/>
        <a:lstStyle/>
        <a:p>
          <a:endParaRPr lang="en-US" sz="1400"/>
        </a:p>
      </dgm:t>
    </dgm:pt>
    <dgm:pt modelId="{C21DD4FD-5C2A-4DC4-9E58-F4C65E180BFC}">
      <dgm:prSet phldrT="[Text]" custT="1"/>
      <dgm:spPr>
        <a:xfrm>
          <a:off x="3591043" y="627389"/>
          <a:ext cx="2398909" cy="425183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5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368</a:t>
          </a:r>
          <a:r>
            <a:rPr lang="en-US" sz="105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records after duplicates are removed</a:t>
          </a:r>
          <a:endParaRPr lang="en-US" sz="105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9527A79C-B4E2-4816-BD0A-E237D7FBDBE0}" type="sibTrans" cxnId="{ABA519D6-2821-4B6C-B6C2-97911EE25383}">
      <dgm:prSet/>
      <dgm:spPr/>
      <dgm:t>
        <a:bodyPr/>
        <a:lstStyle/>
        <a:p>
          <a:endParaRPr lang="en-US" sz="1400"/>
        </a:p>
      </dgm:t>
    </dgm:pt>
    <dgm:pt modelId="{AC69458B-852E-41C5-AFF7-E839F040CD40}" type="parTrans" cxnId="{ABA519D6-2821-4B6C-B6C2-97911EE25383}">
      <dgm:prSet/>
      <dgm:spPr>
        <a:xfrm>
          <a:off x="4639561" y="380594"/>
          <a:ext cx="91440" cy="15345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71543"/>
              </a:lnTo>
              <a:lnTo>
                <a:pt x="52687" y="71543"/>
              </a:lnTo>
              <a:lnTo>
                <a:pt x="52687" y="153458"/>
              </a:lnTo>
            </a:path>
          </a:pathLst>
        </a:custGeom>
        <a:noFill/>
        <a:ln w="19050" cap="flat" cmpd="sng" algn="ctr">
          <a:solidFill>
            <a:srgbClr val="94B6D2">
              <a:shade val="6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 sz="1400"/>
        </a:p>
      </dgm:t>
    </dgm:pt>
    <dgm:pt modelId="{D001CA59-CE31-46D8-8B72-D8D4A04B1216}">
      <dgm:prSet custT="1"/>
      <dgm:spPr>
        <a:xfrm>
          <a:off x="2355800" y="3630034"/>
          <a:ext cx="1463625" cy="647112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Group B</a:t>
          </a:r>
        </a:p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8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studies for assessment of </a:t>
          </a:r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prognostic performance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1267C504-B9E0-4450-9D98-B018206A5F2A}" type="parTrans" cxnId="{3DFEF149-C7D6-4E25-AD6F-7B5493D4C72E}">
      <dgm:prSet/>
      <dgm:spPr>
        <a:xfrm>
          <a:off x="2147042" y="3199671"/>
          <a:ext cx="842321" cy="33702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55111"/>
              </a:lnTo>
              <a:lnTo>
                <a:pt x="842321" y="255111"/>
              </a:lnTo>
              <a:lnTo>
                <a:pt x="842321" y="337026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C1E56707-631C-45FD-8FA8-CDF740760D57}" type="sibTrans" cxnId="{3DFEF149-C7D6-4E25-AD6F-7B5493D4C72E}">
      <dgm:prSet/>
      <dgm:spPr/>
      <dgm:t>
        <a:bodyPr/>
        <a:lstStyle/>
        <a:p>
          <a:endParaRPr lang="en-US"/>
        </a:p>
      </dgm:t>
    </dgm:pt>
    <dgm:pt modelId="{5056C398-76BD-47E7-B353-B91616A5D84E}">
      <dgm:prSet custT="1"/>
      <dgm:spPr>
        <a:xfrm>
          <a:off x="1461600" y="2868425"/>
          <a:ext cx="1567381" cy="424582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31 studies reviewed for potential inclusion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4303AF29-F875-408B-A6DA-B53A25005FF2}" type="parTrans" cxnId="{37C8A235-6206-4F83-B4B1-4FCDCADD5411}">
      <dgm:prSet/>
      <dgm:spPr>
        <a:xfrm>
          <a:off x="2147042" y="2373833"/>
          <a:ext cx="1201580" cy="401255"/>
        </a:xfrm>
        <a:custGeom>
          <a:avLst/>
          <a:gdLst/>
          <a:ahLst/>
          <a:cxnLst/>
          <a:rect l="0" t="0" r="0" b="0"/>
          <a:pathLst>
            <a:path>
              <a:moveTo>
                <a:pt x="1201580" y="0"/>
              </a:moveTo>
              <a:lnTo>
                <a:pt x="1201580" y="319340"/>
              </a:lnTo>
              <a:lnTo>
                <a:pt x="0" y="319340"/>
              </a:lnTo>
              <a:lnTo>
                <a:pt x="0" y="401255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C73C5A6D-764D-4566-9FE0-41912276CBB5}" type="sibTrans" cxnId="{37C8A235-6206-4F83-B4B1-4FCDCADD5411}">
      <dgm:prSet/>
      <dgm:spPr/>
      <dgm:t>
        <a:bodyPr/>
        <a:lstStyle/>
        <a:p>
          <a:endParaRPr lang="en-US"/>
        </a:p>
      </dgm:t>
    </dgm:pt>
    <dgm:pt modelId="{C7CCACC5-29ED-4C73-8586-6A7BF65A462E}">
      <dgm:prSet custT="1"/>
      <dgm:spPr>
        <a:xfrm>
          <a:off x="679292" y="3630034"/>
          <a:ext cx="1480010" cy="766945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23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studies underwent quality assessment using QUADAS 2 tool</a:t>
          </a:r>
        </a:p>
        <a:p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(diagnostic performance)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71AA77F8-B90C-48B6-BB86-C318080BAC68}" type="parTrans" cxnId="{D8FB3387-ACEC-4BCD-897C-31422EFD26AB}">
      <dgm:prSet/>
      <dgm:spPr>
        <a:xfrm>
          <a:off x="1321049" y="3199671"/>
          <a:ext cx="825993" cy="337026"/>
        </a:xfrm>
        <a:custGeom>
          <a:avLst/>
          <a:gdLst/>
          <a:ahLst/>
          <a:cxnLst/>
          <a:rect l="0" t="0" r="0" b="0"/>
          <a:pathLst>
            <a:path>
              <a:moveTo>
                <a:pt x="825993" y="0"/>
              </a:moveTo>
              <a:lnTo>
                <a:pt x="825993" y="255111"/>
              </a:lnTo>
              <a:lnTo>
                <a:pt x="0" y="255111"/>
              </a:lnTo>
              <a:lnTo>
                <a:pt x="0" y="337026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4258D455-FF5B-4A1C-B36A-EEBC6334C04F}" type="sibTrans" cxnId="{D8FB3387-ACEC-4BCD-897C-31422EFD26AB}">
      <dgm:prSet/>
      <dgm:spPr/>
      <dgm:t>
        <a:bodyPr/>
        <a:lstStyle/>
        <a:p>
          <a:endParaRPr lang="en-US"/>
        </a:p>
      </dgm:t>
    </dgm:pt>
    <dgm:pt modelId="{6599EF0E-5BEE-4282-839E-7A816FDA2EE7}">
      <dgm:prSet custT="1"/>
      <dgm:spPr>
        <a:xfrm>
          <a:off x="3888635" y="2875691"/>
          <a:ext cx="2892676" cy="763155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Group Z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:  20 full text articles excluded because</a:t>
          </a:r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:</a:t>
          </a:r>
        </a:p>
        <a:p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- incomplete anatomic or outcome data (n=16)</a:t>
          </a:r>
        </a:p>
        <a:p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- no methodology described for TID assessment (n=5)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66B00EEB-D3A3-4523-B3E1-583BAF620155}" type="parTrans" cxnId="{AC3BAD49-1DA1-4315-A7CF-1E7BF220BF91}">
      <dgm:prSet/>
      <dgm:spPr>
        <a:xfrm>
          <a:off x="3348623" y="2373833"/>
          <a:ext cx="1888102" cy="40852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26606"/>
              </a:lnTo>
              <a:lnTo>
                <a:pt x="1888102" y="326606"/>
              </a:lnTo>
              <a:lnTo>
                <a:pt x="1888102" y="408521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57F2F147-63DA-4A80-B109-45ACAF7B295E}" type="sibTrans" cxnId="{AC3BAD49-1DA1-4315-A7CF-1E7BF220BF91}">
      <dgm:prSet/>
      <dgm:spPr/>
      <dgm:t>
        <a:bodyPr/>
        <a:lstStyle/>
        <a:p>
          <a:endParaRPr lang="en-US"/>
        </a:p>
      </dgm:t>
    </dgm:pt>
    <dgm:pt modelId="{DD9AD388-4F65-494D-9E40-72A14BA15340}">
      <dgm:prSet custT="1"/>
      <dgm:spPr>
        <a:xfrm>
          <a:off x="103153" y="4654146"/>
          <a:ext cx="1244794" cy="718062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Group A</a:t>
          </a:r>
        </a:p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13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studies included in the meta analysis  for </a:t>
          </a:r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diagnostic accuracy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394DEFB4-AAFE-4DC2-A629-C919D006913F}" type="parTrans" cxnId="{4C822A26-5D72-41AD-8619-BA5EDD554363}">
      <dgm:prSet/>
      <dgm:spPr>
        <a:xfrm>
          <a:off x="627302" y="4303644"/>
          <a:ext cx="693747" cy="257165"/>
        </a:xfrm>
        <a:custGeom>
          <a:avLst/>
          <a:gdLst/>
          <a:ahLst/>
          <a:cxnLst/>
          <a:rect l="0" t="0" r="0" b="0"/>
          <a:pathLst>
            <a:path>
              <a:moveTo>
                <a:pt x="693747" y="0"/>
              </a:moveTo>
              <a:lnTo>
                <a:pt x="693747" y="175250"/>
              </a:lnTo>
              <a:lnTo>
                <a:pt x="0" y="175250"/>
              </a:lnTo>
              <a:lnTo>
                <a:pt x="0" y="257165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E6E24878-40A2-404A-833F-54918F3311B2}" type="sibTrans" cxnId="{4C822A26-5D72-41AD-8619-BA5EDD554363}">
      <dgm:prSet/>
      <dgm:spPr/>
      <dgm:t>
        <a:bodyPr/>
        <a:lstStyle/>
        <a:p>
          <a:endParaRPr lang="en-US"/>
        </a:p>
      </dgm:t>
    </dgm:pt>
    <dgm:pt modelId="{DD807BB5-75BF-4BFE-95C2-49B3663F2BBD}">
      <dgm:prSet custT="1"/>
      <dgm:spPr>
        <a:xfrm>
          <a:off x="1544444" y="4654146"/>
          <a:ext cx="1190997" cy="561490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w Cen MT"/>
              <a:ea typeface="+mn-ea"/>
              <a:cs typeface="+mn-cs"/>
            </a:rPr>
            <a:t>Group C</a:t>
          </a:r>
        </a:p>
        <a:p>
          <a:r>
            <a:rPr lang="en-US" sz="100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w Cen MT"/>
              <a:ea typeface="+mn-ea"/>
              <a:cs typeface="+mn-cs"/>
            </a:rPr>
            <a:t>10</a:t>
          </a:r>
          <a:r>
            <a:rPr lang="en-US" sz="10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w Cen MT"/>
              <a:ea typeface="+mn-ea"/>
              <a:cs typeface="+mn-cs"/>
            </a:rPr>
            <a:t> studies incomplete patient level data</a:t>
          </a:r>
          <a:endParaRPr lang="en-US" sz="10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A6F7CD8A-77C1-4AF2-A631-1534C8515591}" type="parTrans" cxnId="{EBD6B356-5ADA-4714-A306-32B85CA762F4}">
      <dgm:prSet/>
      <dgm:spPr>
        <a:xfrm>
          <a:off x="1321049" y="4303644"/>
          <a:ext cx="720645" cy="25716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5250"/>
              </a:lnTo>
              <a:lnTo>
                <a:pt x="720645" y="175250"/>
              </a:lnTo>
              <a:lnTo>
                <a:pt x="720645" y="257165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E9BA190C-B448-4E7A-90EB-18FB55D0E0D7}" type="sibTrans" cxnId="{EBD6B356-5ADA-4714-A306-32B85CA762F4}">
      <dgm:prSet/>
      <dgm:spPr/>
      <dgm:t>
        <a:bodyPr/>
        <a:lstStyle/>
        <a:p>
          <a:endParaRPr lang="en-US"/>
        </a:p>
      </dgm:t>
    </dgm:pt>
    <dgm:pt modelId="{7CB339E5-5D13-4C84-B280-6FAAB1EBEEA3}">
      <dgm:prSet custT="1"/>
      <dgm:spPr>
        <a:xfrm>
          <a:off x="3486185" y="34204"/>
          <a:ext cx="2594688" cy="439725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gm:spPr>
      <dgm:t>
        <a:bodyPr/>
        <a:lstStyle/>
        <a:p>
          <a:r>
            <a:rPr lang="en-US" sz="1050" b="1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525</a:t>
          </a:r>
          <a:r>
            <a:rPr lang="en-US" sz="105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records identified after database  search</a:t>
          </a:r>
          <a:endParaRPr lang="en-US" sz="105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gm:t>
    </dgm:pt>
    <dgm:pt modelId="{3FA3B31C-1168-44FF-B8D8-A713383B633F}" type="parTrans" cxnId="{EB7434BD-643F-4580-97CC-F0A43E52A272}">
      <dgm:prSet/>
      <dgm:spPr/>
      <dgm:t>
        <a:bodyPr/>
        <a:lstStyle/>
        <a:p>
          <a:endParaRPr lang="en-US"/>
        </a:p>
      </dgm:t>
    </dgm:pt>
    <dgm:pt modelId="{098AB771-8784-4B65-93B0-198F2493416C}" type="sibTrans" cxnId="{EB7434BD-643F-4580-97CC-F0A43E52A272}">
      <dgm:prSet/>
      <dgm:spPr/>
      <dgm:t>
        <a:bodyPr/>
        <a:lstStyle/>
        <a:p>
          <a:endParaRPr lang="en-US"/>
        </a:p>
      </dgm:t>
    </dgm:pt>
    <dgm:pt modelId="{B8173793-3CB9-46AE-96EE-822B91BA486B}" type="pres">
      <dgm:prSet presAssocID="{12781828-0ECD-469D-9422-B32915E19CD7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9A03DF8A-44A1-4B37-BF3D-A3D9DB2CA0EC}" type="pres">
      <dgm:prSet presAssocID="{7CB339E5-5D13-4C84-B280-6FAAB1EBEEA3}" presName="hierRoot1" presStyleCnt="0"/>
      <dgm:spPr/>
    </dgm:pt>
    <dgm:pt modelId="{DA62E2EA-554B-4E1E-A087-4C45A152D6C8}" type="pres">
      <dgm:prSet presAssocID="{7CB339E5-5D13-4C84-B280-6FAAB1EBEEA3}" presName="composite" presStyleCnt="0"/>
      <dgm:spPr/>
    </dgm:pt>
    <dgm:pt modelId="{0116B23F-6F26-4772-A1FD-AE5086DCB5B7}" type="pres">
      <dgm:prSet presAssocID="{7CB339E5-5D13-4C84-B280-6FAAB1EBEEA3}" presName="background" presStyleLbl="node0" presStyleIdx="0" presStyleCnt="1"/>
      <dgm:spPr>
        <a:xfrm>
          <a:off x="3387937" y="-59131"/>
          <a:ext cx="2594688" cy="439725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CE20AF85-4737-4C95-907B-1CE481DCF68E}" type="pres">
      <dgm:prSet presAssocID="{7CB339E5-5D13-4C84-B280-6FAAB1EBEEA3}" presName="text" presStyleLbl="fgAcc0" presStyleIdx="0" presStyleCnt="1" custScaleX="293438" custScaleY="78314" custLinFactNeighborX="2792" custLinFactNeighborY="-19446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3A4C2F8-780D-47EE-844D-0118492FF3D4}" type="pres">
      <dgm:prSet presAssocID="{7CB339E5-5D13-4C84-B280-6FAAB1EBEEA3}" presName="hierChild2" presStyleCnt="0"/>
      <dgm:spPr/>
    </dgm:pt>
    <dgm:pt modelId="{6B44A5C3-2C93-4DB5-9727-C467EB26B818}" type="pres">
      <dgm:prSet presAssocID="{AC69458B-852E-41C5-AFF7-E839F040CD40}" presName="Name10" presStyleLbl="parChTrans1D2" presStyleIdx="0" presStyleCnt="1"/>
      <dgm:spPr/>
      <dgm:t>
        <a:bodyPr/>
        <a:lstStyle/>
        <a:p>
          <a:endParaRPr lang="en-US"/>
        </a:p>
      </dgm:t>
    </dgm:pt>
    <dgm:pt modelId="{661EFEE0-73E8-4057-B4D1-1F2D6C263534}" type="pres">
      <dgm:prSet presAssocID="{C21DD4FD-5C2A-4DC4-9E58-F4C65E180BFC}" presName="hierRoot2" presStyleCnt="0"/>
      <dgm:spPr/>
      <dgm:t>
        <a:bodyPr/>
        <a:lstStyle/>
        <a:p>
          <a:endParaRPr lang="en-US"/>
        </a:p>
      </dgm:t>
    </dgm:pt>
    <dgm:pt modelId="{CE727EF9-6568-461D-A713-86514418E9D0}" type="pres">
      <dgm:prSet presAssocID="{C21DD4FD-5C2A-4DC4-9E58-F4C65E180BFC}" presName="composite2" presStyleCnt="0"/>
      <dgm:spPr/>
      <dgm:t>
        <a:bodyPr/>
        <a:lstStyle/>
        <a:p>
          <a:endParaRPr lang="en-US"/>
        </a:p>
      </dgm:t>
    </dgm:pt>
    <dgm:pt modelId="{01DF9809-8EBA-42BA-8D79-9B12B2DC7BAC}" type="pres">
      <dgm:prSet presAssocID="{C21DD4FD-5C2A-4DC4-9E58-F4C65E180BFC}" presName="background2" presStyleLbl="node2" presStyleIdx="0" presStyleCnt="1"/>
      <dgm:spPr>
        <a:xfrm>
          <a:off x="3492794" y="534052"/>
          <a:ext cx="2398909" cy="425183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26485CEB-AFB9-41C8-B562-3BD3309E36DD}" type="pres">
      <dgm:prSet presAssocID="{C21DD4FD-5C2A-4DC4-9E58-F4C65E180BFC}" presName="text2" presStyleLbl="fgAcc2" presStyleIdx="0" presStyleCnt="1" custScaleX="271297" custScaleY="75724" custLinFactNeighborX="3580" custLinFactNeighborY="-37916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2594BFB-CD12-480A-A6E4-7ABBEA6D940B}" type="pres">
      <dgm:prSet presAssocID="{C21DD4FD-5C2A-4DC4-9E58-F4C65E180BFC}" presName="hierChild3" presStyleCnt="0"/>
      <dgm:spPr/>
      <dgm:t>
        <a:bodyPr/>
        <a:lstStyle/>
        <a:p>
          <a:endParaRPr lang="en-US"/>
        </a:p>
      </dgm:t>
    </dgm:pt>
    <dgm:pt modelId="{A387A3BD-E809-4CAF-9267-D6EE374FCD98}" type="pres">
      <dgm:prSet presAssocID="{BD0F97D6-CDA8-46CD-95EB-5C60EBC0A9A5}" presName="Name17" presStyleLbl="parChTrans1D3" presStyleIdx="0" presStyleCnt="1"/>
      <dgm:spPr/>
      <dgm:t>
        <a:bodyPr/>
        <a:lstStyle/>
        <a:p>
          <a:endParaRPr lang="en-US"/>
        </a:p>
      </dgm:t>
    </dgm:pt>
    <dgm:pt modelId="{ACD43B34-5B5B-4941-889D-F4958EE543FB}" type="pres">
      <dgm:prSet presAssocID="{C0EA6C79-EE6E-4B4B-8E49-F9863A2E9915}" presName="hierRoot3" presStyleCnt="0"/>
      <dgm:spPr/>
      <dgm:t>
        <a:bodyPr/>
        <a:lstStyle/>
        <a:p>
          <a:endParaRPr lang="en-US"/>
        </a:p>
      </dgm:t>
    </dgm:pt>
    <dgm:pt modelId="{D6AA3291-A83A-4E64-8459-75D80C2F66F2}" type="pres">
      <dgm:prSet presAssocID="{C0EA6C79-EE6E-4B4B-8E49-F9863A2E9915}" presName="composite3" presStyleCnt="0"/>
      <dgm:spPr/>
      <dgm:t>
        <a:bodyPr/>
        <a:lstStyle/>
        <a:p>
          <a:endParaRPr lang="en-US"/>
        </a:p>
      </dgm:t>
    </dgm:pt>
    <dgm:pt modelId="{7AD82E37-BF6E-4FB2-943B-0960A5A09FF4}" type="pres">
      <dgm:prSet presAssocID="{C0EA6C79-EE6E-4B4B-8E49-F9863A2E9915}" presName="background3" presStyleLbl="node3" presStyleIdx="0" presStyleCnt="1"/>
      <dgm:spPr>
        <a:xfrm>
          <a:off x="3626460" y="1128523"/>
          <a:ext cx="2068266" cy="388197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C802892D-E7D3-45B3-99E9-CD182AF787F9}" type="pres">
      <dgm:prSet presAssocID="{C0EA6C79-EE6E-4B4B-8E49-F9863A2E9915}" presName="text3" presStyleLbl="fgAcc3" presStyleIdx="0" presStyleCnt="1" custScaleX="233904" custScaleY="69137" custLinFactNeighborY="-5356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A5B4A29-7964-4D65-ACAB-C6CB0A5058C5}" type="pres">
      <dgm:prSet presAssocID="{C0EA6C79-EE6E-4B4B-8E49-F9863A2E9915}" presName="hierChild4" presStyleCnt="0"/>
      <dgm:spPr/>
      <dgm:t>
        <a:bodyPr/>
        <a:lstStyle/>
        <a:p>
          <a:endParaRPr lang="en-US"/>
        </a:p>
      </dgm:t>
    </dgm:pt>
    <dgm:pt modelId="{947A1D55-4DB3-4FDC-AECE-1082347F7737}" type="pres">
      <dgm:prSet presAssocID="{F11A3039-FC49-4D21-8AA5-C7B311F8F1A1}" presName="Name23" presStyleLbl="parChTrans1D4" presStyleIdx="0" presStyleCnt="8"/>
      <dgm:spPr>
        <a:custGeom>
          <a:avLst/>
          <a:gdLst/>
          <a:ahLst/>
          <a:cxnLst/>
          <a:rect l="0" t="0" r="0" b="0"/>
          <a:pathLst>
            <a:path>
              <a:moveTo>
                <a:pt x="885561" y="0"/>
              </a:moveTo>
              <a:lnTo>
                <a:pt x="885561" y="248203"/>
              </a:lnTo>
              <a:lnTo>
                <a:pt x="0" y="248203"/>
              </a:lnTo>
              <a:lnTo>
                <a:pt x="0" y="364216"/>
              </a:lnTo>
            </a:path>
          </a:pathLst>
        </a:custGeom>
      </dgm:spPr>
      <dgm:t>
        <a:bodyPr/>
        <a:lstStyle/>
        <a:p>
          <a:endParaRPr lang="en-US"/>
        </a:p>
      </dgm:t>
    </dgm:pt>
    <dgm:pt modelId="{DBA9CE7F-6FC3-4781-A4C1-C7513424617D}" type="pres">
      <dgm:prSet presAssocID="{38EF6A01-FEB9-4048-8C52-26B04E0AF816}" presName="hierRoot4" presStyleCnt="0"/>
      <dgm:spPr/>
      <dgm:t>
        <a:bodyPr/>
        <a:lstStyle/>
        <a:p>
          <a:endParaRPr lang="en-US"/>
        </a:p>
      </dgm:t>
    </dgm:pt>
    <dgm:pt modelId="{17CC7911-D218-490F-97F2-03850DDCA8F6}" type="pres">
      <dgm:prSet presAssocID="{38EF6A01-FEB9-4048-8C52-26B04E0AF816}" presName="composite4" presStyleCnt="0"/>
      <dgm:spPr/>
      <dgm:t>
        <a:bodyPr/>
        <a:lstStyle/>
        <a:p>
          <a:endParaRPr lang="en-US"/>
        </a:p>
      </dgm:t>
    </dgm:pt>
    <dgm:pt modelId="{C7CD2683-6E39-4465-A73B-0C63C02BF058}" type="pres">
      <dgm:prSet presAssocID="{38EF6A01-FEB9-4048-8C52-26B04E0AF816}" presName="background4" presStyleLbl="node4" presStyleIdx="0" presStyleCnt="8"/>
      <dgm:spPr>
        <a:xfrm>
          <a:off x="1362758" y="1850709"/>
          <a:ext cx="3971729" cy="523124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679B0968-FA09-4E45-A053-819CCA6DC639}" type="pres">
      <dgm:prSet presAssocID="{38EF6A01-FEB9-4048-8C52-26B04E0AF816}" presName="text4" presStyleLbl="fgAcc4" presStyleIdx="0" presStyleCnt="8" custScaleX="449170" custScaleY="93167" custLinFactNeighborX="-78162" custLinFactNeighborY="-39885">
        <dgm:presLayoutVars>
          <dgm:chPref val="3"/>
        </dgm:presLayoutVars>
      </dgm:prSet>
      <dgm:spPr>
        <a:prstGeom prst="roundRect">
          <a:avLst>
            <a:gd name="adj" fmla="val 10000"/>
          </a:avLst>
        </a:prstGeom>
      </dgm:spPr>
      <dgm:t>
        <a:bodyPr/>
        <a:lstStyle/>
        <a:p>
          <a:endParaRPr lang="en-US"/>
        </a:p>
      </dgm:t>
    </dgm:pt>
    <dgm:pt modelId="{67E84683-E809-4B8E-9CF9-FE41C53733C7}" type="pres">
      <dgm:prSet presAssocID="{38EF6A01-FEB9-4048-8C52-26B04E0AF816}" presName="hierChild5" presStyleCnt="0"/>
      <dgm:spPr/>
      <dgm:t>
        <a:bodyPr/>
        <a:lstStyle/>
        <a:p>
          <a:endParaRPr lang="en-US"/>
        </a:p>
      </dgm:t>
    </dgm:pt>
    <dgm:pt modelId="{B5286430-4C90-4FEE-AACD-7FB5EB372121}" type="pres">
      <dgm:prSet presAssocID="{4303AF29-F875-408B-A6DA-B53A25005FF2}" presName="Name23" presStyleLbl="parChTrans1D4" presStyleIdx="1" presStyleCnt="8"/>
      <dgm:spPr/>
      <dgm:t>
        <a:bodyPr/>
        <a:lstStyle/>
        <a:p>
          <a:endParaRPr lang="en-US"/>
        </a:p>
      </dgm:t>
    </dgm:pt>
    <dgm:pt modelId="{343376FA-82DB-45FA-8B49-378EE58B977F}" type="pres">
      <dgm:prSet presAssocID="{5056C398-76BD-47E7-B353-B91616A5D84E}" presName="hierRoot4" presStyleCnt="0"/>
      <dgm:spPr/>
    </dgm:pt>
    <dgm:pt modelId="{D00E1234-F8B3-4429-96A5-642F36532E08}" type="pres">
      <dgm:prSet presAssocID="{5056C398-76BD-47E7-B353-B91616A5D84E}" presName="composite4" presStyleCnt="0"/>
      <dgm:spPr/>
    </dgm:pt>
    <dgm:pt modelId="{9B35C26D-65AA-4C58-A96F-A40DAC36E166}" type="pres">
      <dgm:prSet presAssocID="{5056C398-76BD-47E7-B353-B91616A5D84E}" presName="background4" presStyleLbl="node4" presStyleIdx="1" presStyleCnt="8"/>
      <dgm:spPr>
        <a:xfrm>
          <a:off x="1363352" y="2775089"/>
          <a:ext cx="1567381" cy="424582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A9CE802F-B065-4598-AA01-C44FF0888C18}" type="pres">
      <dgm:prSet presAssocID="{5056C398-76BD-47E7-B353-B91616A5D84E}" presName="text4" presStyleLbl="fgAcc4" presStyleIdx="1" presStyleCnt="8" custScaleX="177258" custScaleY="75617" custLinFactNeighborX="-460" custLinFactNeighborY="-1422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878A5E7-A876-4033-8389-3DFBBCD9EF8E}" type="pres">
      <dgm:prSet presAssocID="{5056C398-76BD-47E7-B353-B91616A5D84E}" presName="hierChild5" presStyleCnt="0"/>
      <dgm:spPr/>
    </dgm:pt>
    <dgm:pt modelId="{9B8B08B8-D060-4959-AA49-49A2B88D57E9}" type="pres">
      <dgm:prSet presAssocID="{71AA77F8-B90C-48B6-BB86-C318080BAC68}" presName="Name23" presStyleLbl="parChTrans1D4" presStyleIdx="2" presStyleCnt="8"/>
      <dgm:spPr/>
      <dgm:t>
        <a:bodyPr/>
        <a:lstStyle/>
        <a:p>
          <a:endParaRPr lang="en-US"/>
        </a:p>
      </dgm:t>
    </dgm:pt>
    <dgm:pt modelId="{DA8F2AB3-3B41-452F-A071-F680FFF8D081}" type="pres">
      <dgm:prSet presAssocID="{C7CCACC5-29ED-4C73-8586-6A7BF65A462E}" presName="hierRoot4" presStyleCnt="0"/>
      <dgm:spPr/>
    </dgm:pt>
    <dgm:pt modelId="{4008F5DB-8BDF-4CBD-BC77-9F9655204470}" type="pres">
      <dgm:prSet presAssocID="{C7CCACC5-29ED-4C73-8586-6A7BF65A462E}" presName="composite4" presStyleCnt="0"/>
      <dgm:spPr/>
    </dgm:pt>
    <dgm:pt modelId="{80D99166-3740-4EE8-A9EB-0CB301DB7ECF}" type="pres">
      <dgm:prSet presAssocID="{C7CCACC5-29ED-4C73-8586-6A7BF65A462E}" presName="background4" presStyleLbl="node4" presStyleIdx="2" presStyleCnt="8"/>
      <dgm:spPr>
        <a:xfrm>
          <a:off x="581044" y="3536698"/>
          <a:ext cx="1480010" cy="766945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0C4195F0-9177-41EC-88F9-2C0B5A67BF91}" type="pres">
      <dgm:prSet presAssocID="{C7CCACC5-29ED-4C73-8586-6A7BF65A462E}" presName="text4" presStyleLbl="fgAcc4" presStyleIdx="2" presStyleCnt="8" custScaleX="167377" custScaleY="13659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B4D576A-799F-41C9-BDD7-2C37900E3F62}" type="pres">
      <dgm:prSet presAssocID="{C7CCACC5-29ED-4C73-8586-6A7BF65A462E}" presName="hierChild5" presStyleCnt="0"/>
      <dgm:spPr/>
    </dgm:pt>
    <dgm:pt modelId="{D7A7B80E-F6CC-48D8-8591-D6D8F8363A55}" type="pres">
      <dgm:prSet presAssocID="{394DEFB4-AAFE-4DC2-A629-C919D006913F}" presName="Name23" presStyleLbl="parChTrans1D4" presStyleIdx="3" presStyleCnt="8"/>
      <dgm:spPr/>
      <dgm:t>
        <a:bodyPr/>
        <a:lstStyle/>
        <a:p>
          <a:endParaRPr lang="en-US"/>
        </a:p>
      </dgm:t>
    </dgm:pt>
    <dgm:pt modelId="{CEEEA809-30DD-44AB-8CC6-1329D08DA83F}" type="pres">
      <dgm:prSet presAssocID="{DD9AD388-4F65-494D-9E40-72A14BA15340}" presName="hierRoot4" presStyleCnt="0"/>
      <dgm:spPr/>
    </dgm:pt>
    <dgm:pt modelId="{531C50B8-D985-434B-89E8-5FA75BFCA720}" type="pres">
      <dgm:prSet presAssocID="{DD9AD388-4F65-494D-9E40-72A14BA15340}" presName="composite4" presStyleCnt="0"/>
      <dgm:spPr/>
    </dgm:pt>
    <dgm:pt modelId="{1EE4E8A7-BBE9-46D6-98D9-D4D857401239}" type="pres">
      <dgm:prSet presAssocID="{DD9AD388-4F65-494D-9E40-72A14BA15340}" presName="background4" presStyleLbl="node4" presStyleIdx="3" presStyleCnt="8"/>
      <dgm:spPr>
        <a:xfrm>
          <a:off x="4904" y="4560810"/>
          <a:ext cx="1244794" cy="718062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03DF8DF5-0AF7-4543-BEA4-199F24156AED}" type="pres">
      <dgm:prSet presAssocID="{DD9AD388-4F65-494D-9E40-72A14BA15340}" presName="text4" presStyleLbl="fgAcc4" presStyleIdx="3" presStyleCnt="8" custScaleX="140776" custScaleY="127885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04BD0CC-C13A-4725-AB50-88EB29D3EB18}" type="pres">
      <dgm:prSet presAssocID="{DD9AD388-4F65-494D-9E40-72A14BA15340}" presName="hierChild5" presStyleCnt="0"/>
      <dgm:spPr/>
    </dgm:pt>
    <dgm:pt modelId="{D5BB3744-2B46-453C-AC47-1F36676778C0}" type="pres">
      <dgm:prSet presAssocID="{A6F7CD8A-77C1-4AF2-A631-1534C8515591}" presName="Name23" presStyleLbl="parChTrans1D4" presStyleIdx="4" presStyleCnt="8"/>
      <dgm:spPr/>
      <dgm:t>
        <a:bodyPr/>
        <a:lstStyle/>
        <a:p>
          <a:endParaRPr lang="en-US"/>
        </a:p>
      </dgm:t>
    </dgm:pt>
    <dgm:pt modelId="{734A4DD1-7DEA-41E2-A6BB-1CAE07FA11FC}" type="pres">
      <dgm:prSet presAssocID="{DD807BB5-75BF-4BFE-95C2-49B3663F2BBD}" presName="hierRoot4" presStyleCnt="0"/>
      <dgm:spPr/>
    </dgm:pt>
    <dgm:pt modelId="{7CB33730-FA30-4BC2-A131-D20363135DA7}" type="pres">
      <dgm:prSet presAssocID="{DD807BB5-75BF-4BFE-95C2-49B3663F2BBD}" presName="composite4" presStyleCnt="0"/>
      <dgm:spPr/>
    </dgm:pt>
    <dgm:pt modelId="{14CA967C-69D4-4A31-A470-6E2727B7B863}" type="pres">
      <dgm:prSet presAssocID="{DD807BB5-75BF-4BFE-95C2-49B3663F2BBD}" presName="background4" presStyleLbl="node4" presStyleIdx="4" presStyleCnt="8"/>
      <dgm:spPr>
        <a:xfrm>
          <a:off x="1446196" y="4560810"/>
          <a:ext cx="1190997" cy="561490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1590B6B2-45F3-4970-9A5E-2DA85349EFA2}" type="pres">
      <dgm:prSet presAssocID="{DD807BB5-75BF-4BFE-95C2-49B3663F2BBD}" presName="text4" presStyleLbl="fgAcc4" presStyleIdx="4" presStyleCnt="8" custScaleX="13469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008B24A-AB2B-4B09-83DF-36EA04EDFF83}" type="pres">
      <dgm:prSet presAssocID="{DD807BB5-75BF-4BFE-95C2-49B3663F2BBD}" presName="hierChild5" presStyleCnt="0"/>
      <dgm:spPr/>
    </dgm:pt>
    <dgm:pt modelId="{32596D3B-0780-40A8-9331-920867EBD6CE}" type="pres">
      <dgm:prSet presAssocID="{1267C504-B9E0-4450-9D98-B018206A5F2A}" presName="Name23" presStyleLbl="parChTrans1D4" presStyleIdx="5" presStyleCnt="8"/>
      <dgm:spPr/>
      <dgm:t>
        <a:bodyPr/>
        <a:lstStyle/>
        <a:p>
          <a:endParaRPr lang="en-US"/>
        </a:p>
      </dgm:t>
    </dgm:pt>
    <dgm:pt modelId="{B48C8F5D-3619-4E42-8055-4A31332A9E7D}" type="pres">
      <dgm:prSet presAssocID="{D001CA59-CE31-46D8-8B72-D8D4A04B1216}" presName="hierRoot4" presStyleCnt="0"/>
      <dgm:spPr/>
    </dgm:pt>
    <dgm:pt modelId="{EB6A41EA-9DE9-4F61-876D-5C6AAB3E3FC5}" type="pres">
      <dgm:prSet presAssocID="{D001CA59-CE31-46D8-8B72-D8D4A04B1216}" presName="composite4" presStyleCnt="0"/>
      <dgm:spPr/>
    </dgm:pt>
    <dgm:pt modelId="{4770E6D1-52EA-44A5-BA54-563BCC195FBC}" type="pres">
      <dgm:prSet presAssocID="{D001CA59-CE31-46D8-8B72-D8D4A04B1216}" presName="background4" presStyleLbl="node4" presStyleIdx="5" presStyleCnt="8"/>
      <dgm:spPr>
        <a:xfrm>
          <a:off x="2257551" y="3536698"/>
          <a:ext cx="1463625" cy="647112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06CF7725-2F70-42BB-864B-8B3DE6577B9A}" type="pres">
      <dgm:prSet presAssocID="{D001CA59-CE31-46D8-8B72-D8D4A04B1216}" presName="text4" presStyleLbl="fgAcc4" presStyleIdx="5" presStyleCnt="8" custScaleX="165524" custScaleY="11524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5B183A7-0C5A-48A2-A908-F67D462FF7B9}" type="pres">
      <dgm:prSet presAssocID="{D001CA59-CE31-46D8-8B72-D8D4A04B1216}" presName="hierChild5" presStyleCnt="0"/>
      <dgm:spPr/>
    </dgm:pt>
    <dgm:pt modelId="{202B0CB6-3FA0-436A-88D5-42505860020F}" type="pres">
      <dgm:prSet presAssocID="{66B00EEB-D3A3-4523-B3E1-583BAF620155}" presName="Name23" presStyleLbl="parChTrans1D4" presStyleIdx="6" presStyleCnt="8"/>
      <dgm:spPr/>
      <dgm:t>
        <a:bodyPr/>
        <a:lstStyle/>
        <a:p>
          <a:endParaRPr lang="en-US"/>
        </a:p>
      </dgm:t>
    </dgm:pt>
    <dgm:pt modelId="{ACB8F753-C3B2-4D4B-9058-944F59A9E605}" type="pres">
      <dgm:prSet presAssocID="{6599EF0E-5BEE-4282-839E-7A816FDA2EE7}" presName="hierRoot4" presStyleCnt="0"/>
      <dgm:spPr/>
    </dgm:pt>
    <dgm:pt modelId="{5F547329-2E88-47B4-9E9E-C6A75F5FEE14}" type="pres">
      <dgm:prSet presAssocID="{6599EF0E-5BEE-4282-839E-7A816FDA2EE7}" presName="composite4" presStyleCnt="0"/>
      <dgm:spPr/>
    </dgm:pt>
    <dgm:pt modelId="{C7CEE3C8-1FA0-4DFF-9ED9-BF9A56C6AB87}" type="pres">
      <dgm:prSet presAssocID="{6599EF0E-5BEE-4282-839E-7A816FDA2EE7}" presName="background4" presStyleLbl="node4" presStyleIdx="6" presStyleCnt="8"/>
      <dgm:spPr>
        <a:xfrm>
          <a:off x="3790386" y="2782355"/>
          <a:ext cx="2892676" cy="763155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74144E7D-812E-4D4C-82D5-A2D4E2824DB6}" type="pres">
      <dgm:prSet presAssocID="{6599EF0E-5BEE-4282-839E-7A816FDA2EE7}" presName="text4" presStyleLbl="fgAcc4" presStyleIdx="6" presStyleCnt="8" custScaleX="327138" custScaleY="135916" custLinFactNeighborX="-3284" custLinFactNeighborY="-1292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9045B60-3970-47F8-BA5B-40A60BDC833B}" type="pres">
      <dgm:prSet presAssocID="{6599EF0E-5BEE-4282-839E-7A816FDA2EE7}" presName="hierChild5" presStyleCnt="0"/>
      <dgm:spPr/>
    </dgm:pt>
    <dgm:pt modelId="{D11FC04E-96E8-4439-A3AA-3C45DB5E8B98}" type="pres">
      <dgm:prSet presAssocID="{DBA6DA10-6740-4941-AE30-C0073B6C8D12}" presName="Name23" presStyleLbl="parChTrans1D4" presStyleIdx="7" presStyleCnt="8"/>
      <dgm:spPr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48203"/>
              </a:lnTo>
              <a:lnTo>
                <a:pt x="2087195" y="248203"/>
              </a:lnTo>
              <a:lnTo>
                <a:pt x="2087195" y="364216"/>
              </a:lnTo>
            </a:path>
          </a:pathLst>
        </a:custGeom>
      </dgm:spPr>
      <dgm:t>
        <a:bodyPr/>
        <a:lstStyle/>
        <a:p>
          <a:endParaRPr lang="en-US"/>
        </a:p>
      </dgm:t>
    </dgm:pt>
    <dgm:pt modelId="{2A5921DF-A20E-4FE5-83A1-BFD5D194D27F}" type="pres">
      <dgm:prSet presAssocID="{3DE79F65-FA52-4CBA-A0DF-5A79F8DEDA72}" presName="hierRoot4" presStyleCnt="0"/>
      <dgm:spPr/>
      <dgm:t>
        <a:bodyPr/>
        <a:lstStyle/>
        <a:p>
          <a:endParaRPr lang="en-US"/>
        </a:p>
      </dgm:t>
    </dgm:pt>
    <dgm:pt modelId="{7743D03E-DAB8-4207-8B24-B3D0B08FC6C7}" type="pres">
      <dgm:prSet presAssocID="{3DE79F65-FA52-4CBA-A0DF-5A79F8DEDA72}" presName="composite4" presStyleCnt="0"/>
      <dgm:spPr/>
      <dgm:t>
        <a:bodyPr/>
        <a:lstStyle/>
        <a:p>
          <a:endParaRPr lang="en-US"/>
        </a:p>
      </dgm:t>
    </dgm:pt>
    <dgm:pt modelId="{156384C0-5275-4249-B028-55B3A5BCD6E4}" type="pres">
      <dgm:prSet presAssocID="{3DE79F65-FA52-4CBA-A0DF-5A79F8DEDA72}" presName="background4" presStyleLbl="node4" presStyleIdx="7" presStyleCnt="8"/>
      <dgm:spPr>
        <a:xfrm>
          <a:off x="6102379" y="1792028"/>
          <a:ext cx="1045168" cy="538963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gm:spPr>
      <dgm:t>
        <a:bodyPr/>
        <a:lstStyle/>
        <a:p>
          <a:endParaRPr lang="en-US"/>
        </a:p>
      </dgm:t>
    </dgm:pt>
    <dgm:pt modelId="{6CC69C4C-5C4F-42E0-852D-8F4970DEDE63}" type="pres">
      <dgm:prSet presAssocID="{3DE79F65-FA52-4CBA-A0DF-5A79F8DEDA72}" presName="text4" presStyleLbl="fgAcc4" presStyleIdx="7" presStyleCnt="8" custScaleX="118200" custScaleY="95988" custLinFactNeighborX="-13542" custLinFactNeighborY="-50336">
        <dgm:presLayoutVars>
          <dgm:chPref val="3"/>
        </dgm:presLayoutVars>
      </dgm:prSet>
      <dgm:spPr>
        <a:prstGeom prst="roundRect">
          <a:avLst>
            <a:gd name="adj" fmla="val 10000"/>
          </a:avLst>
        </a:prstGeom>
      </dgm:spPr>
      <dgm:t>
        <a:bodyPr/>
        <a:lstStyle/>
        <a:p>
          <a:endParaRPr lang="en-US"/>
        </a:p>
      </dgm:t>
    </dgm:pt>
    <dgm:pt modelId="{CBC3B056-6AD2-4138-A83D-6A01935052D6}" type="pres">
      <dgm:prSet presAssocID="{3DE79F65-FA52-4CBA-A0DF-5A79F8DEDA72}" presName="hierChild5" presStyleCnt="0"/>
      <dgm:spPr/>
      <dgm:t>
        <a:bodyPr/>
        <a:lstStyle/>
        <a:p>
          <a:endParaRPr lang="en-US"/>
        </a:p>
      </dgm:t>
    </dgm:pt>
  </dgm:ptLst>
  <dgm:cxnLst>
    <dgm:cxn modelId="{3585DA90-DE33-4CBA-8786-C95703F71902}" type="presOf" srcId="{3DE79F65-FA52-4CBA-A0DF-5A79F8DEDA72}" destId="{6CC69C4C-5C4F-42E0-852D-8F4970DEDE63}" srcOrd="0" destOrd="0" presId="urn:microsoft.com/office/officeart/2005/8/layout/hierarchy1"/>
    <dgm:cxn modelId="{88690470-5332-4204-94D6-7A317AADC4E5}" type="presOf" srcId="{7CB339E5-5D13-4C84-B280-6FAAB1EBEEA3}" destId="{CE20AF85-4737-4C95-907B-1CE481DCF68E}" srcOrd="0" destOrd="0" presId="urn:microsoft.com/office/officeart/2005/8/layout/hierarchy1"/>
    <dgm:cxn modelId="{D8FB3387-ACEC-4BCD-897C-31422EFD26AB}" srcId="{5056C398-76BD-47E7-B353-B91616A5D84E}" destId="{C7CCACC5-29ED-4C73-8586-6A7BF65A462E}" srcOrd="0" destOrd="0" parTransId="{71AA77F8-B90C-48B6-BB86-C318080BAC68}" sibTransId="{4258D455-FF5B-4A1C-B36A-EEBC6334C04F}"/>
    <dgm:cxn modelId="{42C15E3D-C99E-4239-BDEF-ED3FDB2A1813}" type="presOf" srcId="{C0EA6C79-EE6E-4B4B-8E49-F9863A2E9915}" destId="{C802892D-E7D3-45B3-99E9-CD182AF787F9}" srcOrd="0" destOrd="0" presId="urn:microsoft.com/office/officeart/2005/8/layout/hierarchy1"/>
    <dgm:cxn modelId="{37C8A235-6206-4F83-B4B1-4FCDCADD5411}" srcId="{38EF6A01-FEB9-4048-8C52-26B04E0AF816}" destId="{5056C398-76BD-47E7-B353-B91616A5D84E}" srcOrd="0" destOrd="0" parTransId="{4303AF29-F875-408B-A6DA-B53A25005FF2}" sibTransId="{C73C5A6D-764D-4566-9FE0-41912276CBB5}"/>
    <dgm:cxn modelId="{3DFEF149-C7D6-4E25-AD6F-7B5493D4C72E}" srcId="{5056C398-76BD-47E7-B353-B91616A5D84E}" destId="{D001CA59-CE31-46D8-8B72-D8D4A04B1216}" srcOrd="1" destOrd="0" parTransId="{1267C504-B9E0-4450-9D98-B018206A5F2A}" sibTransId="{C1E56707-631C-45FD-8FA8-CDF740760D57}"/>
    <dgm:cxn modelId="{A391AA4C-685F-490A-9343-DF1ECB3B1F20}" type="presOf" srcId="{66B00EEB-D3A3-4523-B3E1-583BAF620155}" destId="{202B0CB6-3FA0-436A-88D5-42505860020F}" srcOrd="0" destOrd="0" presId="urn:microsoft.com/office/officeart/2005/8/layout/hierarchy1"/>
    <dgm:cxn modelId="{C837C12D-D54B-4485-8A46-CCFA9E7325D1}" srcId="{C0EA6C79-EE6E-4B4B-8E49-F9863A2E9915}" destId="{3DE79F65-FA52-4CBA-A0DF-5A79F8DEDA72}" srcOrd="1" destOrd="0" parTransId="{DBA6DA10-6740-4941-AE30-C0073B6C8D12}" sibTransId="{0E0A74D6-C7F7-47C8-B310-9F2383AD854D}"/>
    <dgm:cxn modelId="{6C24ECF2-A631-4BC6-B984-8AAC3DB3070B}" type="presOf" srcId="{394DEFB4-AAFE-4DC2-A629-C919D006913F}" destId="{D7A7B80E-F6CC-48D8-8591-D6D8F8363A55}" srcOrd="0" destOrd="0" presId="urn:microsoft.com/office/officeart/2005/8/layout/hierarchy1"/>
    <dgm:cxn modelId="{B6C9AA3C-B7D0-4202-93C0-F8FB87DFF19C}" type="presOf" srcId="{C21DD4FD-5C2A-4DC4-9E58-F4C65E180BFC}" destId="{26485CEB-AFB9-41C8-B562-3BD3309E36DD}" srcOrd="0" destOrd="0" presId="urn:microsoft.com/office/officeart/2005/8/layout/hierarchy1"/>
    <dgm:cxn modelId="{167F1D94-420C-471B-BD55-F7096728F6EF}" type="presOf" srcId="{DD9AD388-4F65-494D-9E40-72A14BA15340}" destId="{03DF8DF5-0AF7-4543-BEA4-199F24156AED}" srcOrd="0" destOrd="0" presId="urn:microsoft.com/office/officeart/2005/8/layout/hierarchy1"/>
    <dgm:cxn modelId="{90D7028C-E2CE-4DC6-AB1B-65AC1CE69A91}" type="presOf" srcId="{A6F7CD8A-77C1-4AF2-A631-1534C8515591}" destId="{D5BB3744-2B46-453C-AC47-1F36676778C0}" srcOrd="0" destOrd="0" presId="urn:microsoft.com/office/officeart/2005/8/layout/hierarchy1"/>
    <dgm:cxn modelId="{E7B93E5D-F33A-4534-8DE1-8AAE4B4E4496}" type="presOf" srcId="{DD807BB5-75BF-4BFE-95C2-49B3663F2BBD}" destId="{1590B6B2-45F3-4970-9A5E-2DA85349EFA2}" srcOrd="0" destOrd="0" presId="urn:microsoft.com/office/officeart/2005/8/layout/hierarchy1"/>
    <dgm:cxn modelId="{F5CCF018-9463-475C-AAD1-F02534E6CAED}" srcId="{C21DD4FD-5C2A-4DC4-9E58-F4C65E180BFC}" destId="{C0EA6C79-EE6E-4B4B-8E49-F9863A2E9915}" srcOrd="0" destOrd="0" parTransId="{BD0F97D6-CDA8-46CD-95EB-5C60EBC0A9A5}" sibTransId="{F985F4C3-34FC-47D4-B157-49FE16D488BD}"/>
    <dgm:cxn modelId="{34E81C62-C5A1-43BC-A4E5-BDFCE668FEBF}" type="presOf" srcId="{F11A3039-FC49-4D21-8AA5-C7B311F8F1A1}" destId="{947A1D55-4DB3-4FDC-AECE-1082347F7737}" srcOrd="0" destOrd="0" presId="urn:microsoft.com/office/officeart/2005/8/layout/hierarchy1"/>
    <dgm:cxn modelId="{0A47778F-B8BC-4B9E-A440-98D4026AB445}" type="presOf" srcId="{5056C398-76BD-47E7-B353-B91616A5D84E}" destId="{A9CE802F-B065-4598-AA01-C44FF0888C18}" srcOrd="0" destOrd="0" presId="urn:microsoft.com/office/officeart/2005/8/layout/hierarchy1"/>
    <dgm:cxn modelId="{3FF868CE-5692-4A7E-A18C-4858B370F57A}" type="presOf" srcId="{12781828-0ECD-469D-9422-B32915E19CD7}" destId="{B8173793-3CB9-46AE-96EE-822B91BA486B}" srcOrd="0" destOrd="0" presId="urn:microsoft.com/office/officeart/2005/8/layout/hierarchy1"/>
    <dgm:cxn modelId="{FC2FC67B-E9DB-4113-A147-6DFB2099C384}" type="presOf" srcId="{4303AF29-F875-408B-A6DA-B53A25005FF2}" destId="{B5286430-4C90-4FEE-AACD-7FB5EB372121}" srcOrd="0" destOrd="0" presId="urn:microsoft.com/office/officeart/2005/8/layout/hierarchy1"/>
    <dgm:cxn modelId="{12195DEF-751F-4755-A3F5-1EA074AF5FA8}" type="presOf" srcId="{D001CA59-CE31-46D8-8B72-D8D4A04B1216}" destId="{06CF7725-2F70-42BB-864B-8B3DE6577B9A}" srcOrd="0" destOrd="0" presId="urn:microsoft.com/office/officeart/2005/8/layout/hierarchy1"/>
    <dgm:cxn modelId="{EBD6B356-5ADA-4714-A306-32B85CA762F4}" srcId="{C7CCACC5-29ED-4C73-8586-6A7BF65A462E}" destId="{DD807BB5-75BF-4BFE-95C2-49B3663F2BBD}" srcOrd="1" destOrd="0" parTransId="{A6F7CD8A-77C1-4AF2-A631-1534C8515591}" sibTransId="{E9BA190C-B448-4E7A-90EB-18FB55D0E0D7}"/>
    <dgm:cxn modelId="{8F449C43-1F83-453D-B774-5C9D6B93EE19}" type="presOf" srcId="{DBA6DA10-6740-4941-AE30-C0073B6C8D12}" destId="{D11FC04E-96E8-4439-A3AA-3C45DB5E8B98}" srcOrd="0" destOrd="0" presId="urn:microsoft.com/office/officeart/2005/8/layout/hierarchy1"/>
    <dgm:cxn modelId="{AA4610B9-5C77-4C1F-90A4-6DDAA61E8B46}" srcId="{C0EA6C79-EE6E-4B4B-8E49-F9863A2E9915}" destId="{38EF6A01-FEB9-4048-8C52-26B04E0AF816}" srcOrd="0" destOrd="0" parTransId="{F11A3039-FC49-4D21-8AA5-C7B311F8F1A1}" sibTransId="{30A8F76A-B0D0-4546-AC7E-A9BAB539C623}"/>
    <dgm:cxn modelId="{627DC44F-B0EA-4FDD-8428-99EA8D05AF36}" type="presOf" srcId="{1267C504-B9E0-4450-9D98-B018206A5F2A}" destId="{32596D3B-0780-40A8-9331-920867EBD6CE}" srcOrd="0" destOrd="0" presId="urn:microsoft.com/office/officeart/2005/8/layout/hierarchy1"/>
    <dgm:cxn modelId="{EB7434BD-643F-4580-97CC-F0A43E52A272}" srcId="{12781828-0ECD-469D-9422-B32915E19CD7}" destId="{7CB339E5-5D13-4C84-B280-6FAAB1EBEEA3}" srcOrd="0" destOrd="0" parTransId="{3FA3B31C-1168-44FF-B8D8-A713383B633F}" sibTransId="{098AB771-8784-4B65-93B0-198F2493416C}"/>
    <dgm:cxn modelId="{AC3BAD49-1DA1-4315-A7CF-1E7BF220BF91}" srcId="{38EF6A01-FEB9-4048-8C52-26B04E0AF816}" destId="{6599EF0E-5BEE-4282-839E-7A816FDA2EE7}" srcOrd="1" destOrd="0" parTransId="{66B00EEB-D3A3-4523-B3E1-583BAF620155}" sibTransId="{57F2F147-63DA-4A80-B109-45ACAF7B295E}"/>
    <dgm:cxn modelId="{AE066A04-2035-4CE1-B5C4-7BF996099DB9}" type="presOf" srcId="{BD0F97D6-CDA8-46CD-95EB-5C60EBC0A9A5}" destId="{A387A3BD-E809-4CAF-9267-D6EE374FCD98}" srcOrd="0" destOrd="0" presId="urn:microsoft.com/office/officeart/2005/8/layout/hierarchy1"/>
    <dgm:cxn modelId="{ABA519D6-2821-4B6C-B6C2-97911EE25383}" srcId="{7CB339E5-5D13-4C84-B280-6FAAB1EBEEA3}" destId="{C21DD4FD-5C2A-4DC4-9E58-F4C65E180BFC}" srcOrd="0" destOrd="0" parTransId="{AC69458B-852E-41C5-AFF7-E839F040CD40}" sibTransId="{9527A79C-B4E2-4816-BD0A-E237D7FBDBE0}"/>
    <dgm:cxn modelId="{18A37A42-63EC-4D4F-A270-975DE271E927}" type="presOf" srcId="{6599EF0E-5BEE-4282-839E-7A816FDA2EE7}" destId="{74144E7D-812E-4D4C-82D5-A2D4E2824DB6}" srcOrd="0" destOrd="0" presId="urn:microsoft.com/office/officeart/2005/8/layout/hierarchy1"/>
    <dgm:cxn modelId="{8988F188-8954-46AC-88A0-A56FFADFEA00}" type="presOf" srcId="{71AA77F8-B90C-48B6-BB86-C318080BAC68}" destId="{9B8B08B8-D060-4959-AA49-49A2B88D57E9}" srcOrd="0" destOrd="0" presId="urn:microsoft.com/office/officeart/2005/8/layout/hierarchy1"/>
    <dgm:cxn modelId="{4C822A26-5D72-41AD-8619-BA5EDD554363}" srcId="{C7CCACC5-29ED-4C73-8586-6A7BF65A462E}" destId="{DD9AD388-4F65-494D-9E40-72A14BA15340}" srcOrd="0" destOrd="0" parTransId="{394DEFB4-AAFE-4DC2-A629-C919D006913F}" sibTransId="{E6E24878-40A2-404A-833F-54918F3311B2}"/>
    <dgm:cxn modelId="{C2B9DD95-39F4-4EBB-B6A2-FAFFFD4C53CB}" type="presOf" srcId="{38EF6A01-FEB9-4048-8C52-26B04E0AF816}" destId="{679B0968-FA09-4E45-A053-819CCA6DC639}" srcOrd="0" destOrd="0" presId="urn:microsoft.com/office/officeart/2005/8/layout/hierarchy1"/>
    <dgm:cxn modelId="{FEDEAA51-16F6-4FF6-AEED-33A49B09757C}" type="presOf" srcId="{C7CCACC5-29ED-4C73-8586-6A7BF65A462E}" destId="{0C4195F0-9177-41EC-88F9-2C0B5A67BF91}" srcOrd="0" destOrd="0" presId="urn:microsoft.com/office/officeart/2005/8/layout/hierarchy1"/>
    <dgm:cxn modelId="{62892E81-9B7E-4427-B59E-2C5ADC4DD0A7}" type="presOf" srcId="{AC69458B-852E-41C5-AFF7-E839F040CD40}" destId="{6B44A5C3-2C93-4DB5-9727-C467EB26B818}" srcOrd="0" destOrd="0" presId="urn:microsoft.com/office/officeart/2005/8/layout/hierarchy1"/>
    <dgm:cxn modelId="{932C16F0-81C1-4D98-BF64-702A81D90F1F}" type="presParOf" srcId="{B8173793-3CB9-46AE-96EE-822B91BA486B}" destId="{9A03DF8A-44A1-4B37-BF3D-A3D9DB2CA0EC}" srcOrd="0" destOrd="0" presId="urn:microsoft.com/office/officeart/2005/8/layout/hierarchy1"/>
    <dgm:cxn modelId="{FFB1323A-DE35-4F9D-AF59-59ED16A64D3D}" type="presParOf" srcId="{9A03DF8A-44A1-4B37-BF3D-A3D9DB2CA0EC}" destId="{DA62E2EA-554B-4E1E-A087-4C45A152D6C8}" srcOrd="0" destOrd="0" presId="urn:microsoft.com/office/officeart/2005/8/layout/hierarchy1"/>
    <dgm:cxn modelId="{36153212-F9E5-4B3A-901D-5522DC96BC8B}" type="presParOf" srcId="{DA62E2EA-554B-4E1E-A087-4C45A152D6C8}" destId="{0116B23F-6F26-4772-A1FD-AE5086DCB5B7}" srcOrd="0" destOrd="0" presId="urn:microsoft.com/office/officeart/2005/8/layout/hierarchy1"/>
    <dgm:cxn modelId="{23A345F9-2CD9-4EB4-ABC8-34502215CE8E}" type="presParOf" srcId="{DA62E2EA-554B-4E1E-A087-4C45A152D6C8}" destId="{CE20AF85-4737-4C95-907B-1CE481DCF68E}" srcOrd="1" destOrd="0" presId="urn:microsoft.com/office/officeart/2005/8/layout/hierarchy1"/>
    <dgm:cxn modelId="{D30EB586-F3B3-4F79-9B9B-179D26134743}" type="presParOf" srcId="{9A03DF8A-44A1-4B37-BF3D-A3D9DB2CA0EC}" destId="{03A4C2F8-780D-47EE-844D-0118492FF3D4}" srcOrd="1" destOrd="0" presId="urn:microsoft.com/office/officeart/2005/8/layout/hierarchy1"/>
    <dgm:cxn modelId="{C44B7B5B-C8E2-4BF9-BB09-D9FC095ECEF3}" type="presParOf" srcId="{03A4C2F8-780D-47EE-844D-0118492FF3D4}" destId="{6B44A5C3-2C93-4DB5-9727-C467EB26B818}" srcOrd="0" destOrd="0" presId="urn:microsoft.com/office/officeart/2005/8/layout/hierarchy1"/>
    <dgm:cxn modelId="{D56AEB38-D438-4395-8E2D-2E4F696F6AC2}" type="presParOf" srcId="{03A4C2F8-780D-47EE-844D-0118492FF3D4}" destId="{661EFEE0-73E8-4057-B4D1-1F2D6C263534}" srcOrd="1" destOrd="0" presId="urn:microsoft.com/office/officeart/2005/8/layout/hierarchy1"/>
    <dgm:cxn modelId="{1AD492F6-DB97-4486-AF9A-709D1F4A66C1}" type="presParOf" srcId="{661EFEE0-73E8-4057-B4D1-1F2D6C263534}" destId="{CE727EF9-6568-461D-A713-86514418E9D0}" srcOrd="0" destOrd="0" presId="urn:microsoft.com/office/officeart/2005/8/layout/hierarchy1"/>
    <dgm:cxn modelId="{B444DB32-D44A-477D-95D6-02DF52419928}" type="presParOf" srcId="{CE727EF9-6568-461D-A713-86514418E9D0}" destId="{01DF9809-8EBA-42BA-8D79-9B12B2DC7BAC}" srcOrd="0" destOrd="0" presId="urn:microsoft.com/office/officeart/2005/8/layout/hierarchy1"/>
    <dgm:cxn modelId="{A747FD91-23D3-43E0-BAC1-007F06F0FF7C}" type="presParOf" srcId="{CE727EF9-6568-461D-A713-86514418E9D0}" destId="{26485CEB-AFB9-41C8-B562-3BD3309E36DD}" srcOrd="1" destOrd="0" presId="urn:microsoft.com/office/officeart/2005/8/layout/hierarchy1"/>
    <dgm:cxn modelId="{031567A5-DE00-43CF-8E41-18DCD9B4C41D}" type="presParOf" srcId="{661EFEE0-73E8-4057-B4D1-1F2D6C263534}" destId="{02594BFB-CD12-480A-A6E4-7ABBEA6D940B}" srcOrd="1" destOrd="0" presId="urn:microsoft.com/office/officeart/2005/8/layout/hierarchy1"/>
    <dgm:cxn modelId="{FDCE5E96-CE16-49E3-A8AC-17E3FF081705}" type="presParOf" srcId="{02594BFB-CD12-480A-A6E4-7ABBEA6D940B}" destId="{A387A3BD-E809-4CAF-9267-D6EE374FCD98}" srcOrd="0" destOrd="0" presId="urn:microsoft.com/office/officeart/2005/8/layout/hierarchy1"/>
    <dgm:cxn modelId="{07C9E83D-5E9B-4A08-8F20-B8328D89EBAB}" type="presParOf" srcId="{02594BFB-CD12-480A-A6E4-7ABBEA6D940B}" destId="{ACD43B34-5B5B-4941-889D-F4958EE543FB}" srcOrd="1" destOrd="0" presId="urn:microsoft.com/office/officeart/2005/8/layout/hierarchy1"/>
    <dgm:cxn modelId="{DE325A05-2F06-4919-A993-ACAACCEA0CB9}" type="presParOf" srcId="{ACD43B34-5B5B-4941-889D-F4958EE543FB}" destId="{D6AA3291-A83A-4E64-8459-75D80C2F66F2}" srcOrd="0" destOrd="0" presId="urn:microsoft.com/office/officeart/2005/8/layout/hierarchy1"/>
    <dgm:cxn modelId="{A325AC4F-6734-4C97-AC09-0803973EB405}" type="presParOf" srcId="{D6AA3291-A83A-4E64-8459-75D80C2F66F2}" destId="{7AD82E37-BF6E-4FB2-943B-0960A5A09FF4}" srcOrd="0" destOrd="0" presId="urn:microsoft.com/office/officeart/2005/8/layout/hierarchy1"/>
    <dgm:cxn modelId="{3C21071B-C2C5-440C-A81B-2969A87798DB}" type="presParOf" srcId="{D6AA3291-A83A-4E64-8459-75D80C2F66F2}" destId="{C802892D-E7D3-45B3-99E9-CD182AF787F9}" srcOrd="1" destOrd="0" presId="urn:microsoft.com/office/officeart/2005/8/layout/hierarchy1"/>
    <dgm:cxn modelId="{A01C1062-3D35-4FA3-BFE6-1325A774A92A}" type="presParOf" srcId="{ACD43B34-5B5B-4941-889D-F4958EE543FB}" destId="{5A5B4A29-7964-4D65-ACAB-C6CB0A5058C5}" srcOrd="1" destOrd="0" presId="urn:microsoft.com/office/officeart/2005/8/layout/hierarchy1"/>
    <dgm:cxn modelId="{DF65CC3B-AF67-4F22-BB99-EE241DBA8BB2}" type="presParOf" srcId="{5A5B4A29-7964-4D65-ACAB-C6CB0A5058C5}" destId="{947A1D55-4DB3-4FDC-AECE-1082347F7737}" srcOrd="0" destOrd="0" presId="urn:microsoft.com/office/officeart/2005/8/layout/hierarchy1"/>
    <dgm:cxn modelId="{1AAB7FC9-F31E-4F41-B01F-38F3CAA5CCFC}" type="presParOf" srcId="{5A5B4A29-7964-4D65-ACAB-C6CB0A5058C5}" destId="{DBA9CE7F-6FC3-4781-A4C1-C7513424617D}" srcOrd="1" destOrd="0" presId="urn:microsoft.com/office/officeart/2005/8/layout/hierarchy1"/>
    <dgm:cxn modelId="{746F66EA-5C47-4B04-967C-2ECE8C29AC18}" type="presParOf" srcId="{DBA9CE7F-6FC3-4781-A4C1-C7513424617D}" destId="{17CC7911-D218-490F-97F2-03850DDCA8F6}" srcOrd="0" destOrd="0" presId="urn:microsoft.com/office/officeart/2005/8/layout/hierarchy1"/>
    <dgm:cxn modelId="{ACC052D4-DBDE-4647-B2D5-66792C11E711}" type="presParOf" srcId="{17CC7911-D218-490F-97F2-03850DDCA8F6}" destId="{C7CD2683-6E39-4465-A73B-0C63C02BF058}" srcOrd="0" destOrd="0" presId="urn:microsoft.com/office/officeart/2005/8/layout/hierarchy1"/>
    <dgm:cxn modelId="{FB6458A4-9E25-4656-A382-21E219BC9C62}" type="presParOf" srcId="{17CC7911-D218-490F-97F2-03850DDCA8F6}" destId="{679B0968-FA09-4E45-A053-819CCA6DC639}" srcOrd="1" destOrd="0" presId="urn:microsoft.com/office/officeart/2005/8/layout/hierarchy1"/>
    <dgm:cxn modelId="{5532CD31-F119-4D5A-82B7-F206CBB15432}" type="presParOf" srcId="{DBA9CE7F-6FC3-4781-A4C1-C7513424617D}" destId="{67E84683-E809-4B8E-9CF9-FE41C53733C7}" srcOrd="1" destOrd="0" presId="urn:microsoft.com/office/officeart/2005/8/layout/hierarchy1"/>
    <dgm:cxn modelId="{371DDA35-A101-43E1-8305-620F2403C5B9}" type="presParOf" srcId="{67E84683-E809-4B8E-9CF9-FE41C53733C7}" destId="{B5286430-4C90-4FEE-AACD-7FB5EB372121}" srcOrd="0" destOrd="0" presId="urn:microsoft.com/office/officeart/2005/8/layout/hierarchy1"/>
    <dgm:cxn modelId="{0FB6406A-38C9-4E0E-A058-5332E415D051}" type="presParOf" srcId="{67E84683-E809-4B8E-9CF9-FE41C53733C7}" destId="{343376FA-82DB-45FA-8B49-378EE58B977F}" srcOrd="1" destOrd="0" presId="urn:microsoft.com/office/officeart/2005/8/layout/hierarchy1"/>
    <dgm:cxn modelId="{3B860CD4-530A-4CDC-9C59-67F351455B20}" type="presParOf" srcId="{343376FA-82DB-45FA-8B49-378EE58B977F}" destId="{D00E1234-F8B3-4429-96A5-642F36532E08}" srcOrd="0" destOrd="0" presId="urn:microsoft.com/office/officeart/2005/8/layout/hierarchy1"/>
    <dgm:cxn modelId="{F94A955F-AB9A-4702-AAF0-60D6578AEEAC}" type="presParOf" srcId="{D00E1234-F8B3-4429-96A5-642F36532E08}" destId="{9B35C26D-65AA-4C58-A96F-A40DAC36E166}" srcOrd="0" destOrd="0" presId="urn:microsoft.com/office/officeart/2005/8/layout/hierarchy1"/>
    <dgm:cxn modelId="{4884EC2F-8517-49B1-88EB-BC51906A6CAC}" type="presParOf" srcId="{D00E1234-F8B3-4429-96A5-642F36532E08}" destId="{A9CE802F-B065-4598-AA01-C44FF0888C18}" srcOrd="1" destOrd="0" presId="urn:microsoft.com/office/officeart/2005/8/layout/hierarchy1"/>
    <dgm:cxn modelId="{471CF904-A119-4EA7-A10D-181FAD585898}" type="presParOf" srcId="{343376FA-82DB-45FA-8B49-378EE58B977F}" destId="{C878A5E7-A876-4033-8389-3DFBBCD9EF8E}" srcOrd="1" destOrd="0" presId="urn:microsoft.com/office/officeart/2005/8/layout/hierarchy1"/>
    <dgm:cxn modelId="{9058CBC2-69A8-4309-8421-6BC361BC027F}" type="presParOf" srcId="{C878A5E7-A876-4033-8389-3DFBBCD9EF8E}" destId="{9B8B08B8-D060-4959-AA49-49A2B88D57E9}" srcOrd="0" destOrd="0" presId="urn:microsoft.com/office/officeart/2005/8/layout/hierarchy1"/>
    <dgm:cxn modelId="{078A4E3C-01AB-4D01-98DE-2C15881FFB09}" type="presParOf" srcId="{C878A5E7-A876-4033-8389-3DFBBCD9EF8E}" destId="{DA8F2AB3-3B41-452F-A071-F680FFF8D081}" srcOrd="1" destOrd="0" presId="urn:microsoft.com/office/officeart/2005/8/layout/hierarchy1"/>
    <dgm:cxn modelId="{5C2290EA-F848-4DAF-A3A3-E870C9B288FE}" type="presParOf" srcId="{DA8F2AB3-3B41-452F-A071-F680FFF8D081}" destId="{4008F5DB-8BDF-4CBD-BC77-9F9655204470}" srcOrd="0" destOrd="0" presId="urn:microsoft.com/office/officeart/2005/8/layout/hierarchy1"/>
    <dgm:cxn modelId="{932664EC-51CF-4B69-9005-0F9C08BC299B}" type="presParOf" srcId="{4008F5DB-8BDF-4CBD-BC77-9F9655204470}" destId="{80D99166-3740-4EE8-A9EB-0CB301DB7ECF}" srcOrd="0" destOrd="0" presId="urn:microsoft.com/office/officeart/2005/8/layout/hierarchy1"/>
    <dgm:cxn modelId="{0E85BF55-FA5D-494B-8AFE-11D81184D913}" type="presParOf" srcId="{4008F5DB-8BDF-4CBD-BC77-9F9655204470}" destId="{0C4195F0-9177-41EC-88F9-2C0B5A67BF91}" srcOrd="1" destOrd="0" presId="urn:microsoft.com/office/officeart/2005/8/layout/hierarchy1"/>
    <dgm:cxn modelId="{A157EE3E-58F8-45D9-8AE7-E06355B8CEAE}" type="presParOf" srcId="{DA8F2AB3-3B41-452F-A071-F680FFF8D081}" destId="{CB4D576A-799F-41C9-BDD7-2C37900E3F62}" srcOrd="1" destOrd="0" presId="urn:microsoft.com/office/officeart/2005/8/layout/hierarchy1"/>
    <dgm:cxn modelId="{518FDCE4-7BEE-4A1D-AA49-AE8A54A92B25}" type="presParOf" srcId="{CB4D576A-799F-41C9-BDD7-2C37900E3F62}" destId="{D7A7B80E-F6CC-48D8-8591-D6D8F8363A55}" srcOrd="0" destOrd="0" presId="urn:microsoft.com/office/officeart/2005/8/layout/hierarchy1"/>
    <dgm:cxn modelId="{8B068202-3F40-4A25-9491-5D6C4C8A43C3}" type="presParOf" srcId="{CB4D576A-799F-41C9-BDD7-2C37900E3F62}" destId="{CEEEA809-30DD-44AB-8CC6-1329D08DA83F}" srcOrd="1" destOrd="0" presId="urn:microsoft.com/office/officeart/2005/8/layout/hierarchy1"/>
    <dgm:cxn modelId="{E081133B-0FBB-4EFC-BD64-2F439F760224}" type="presParOf" srcId="{CEEEA809-30DD-44AB-8CC6-1329D08DA83F}" destId="{531C50B8-D985-434B-89E8-5FA75BFCA720}" srcOrd="0" destOrd="0" presId="urn:microsoft.com/office/officeart/2005/8/layout/hierarchy1"/>
    <dgm:cxn modelId="{395301D6-0317-4634-9C54-DC18B2B1617C}" type="presParOf" srcId="{531C50B8-D985-434B-89E8-5FA75BFCA720}" destId="{1EE4E8A7-BBE9-46D6-98D9-D4D857401239}" srcOrd="0" destOrd="0" presId="urn:microsoft.com/office/officeart/2005/8/layout/hierarchy1"/>
    <dgm:cxn modelId="{159B5A4F-6B4F-440D-BE1B-025B4C17F1A0}" type="presParOf" srcId="{531C50B8-D985-434B-89E8-5FA75BFCA720}" destId="{03DF8DF5-0AF7-4543-BEA4-199F24156AED}" srcOrd="1" destOrd="0" presId="urn:microsoft.com/office/officeart/2005/8/layout/hierarchy1"/>
    <dgm:cxn modelId="{EDA13527-E499-4528-B3F6-70BBFC3CDEA5}" type="presParOf" srcId="{CEEEA809-30DD-44AB-8CC6-1329D08DA83F}" destId="{204BD0CC-C13A-4725-AB50-88EB29D3EB18}" srcOrd="1" destOrd="0" presId="urn:microsoft.com/office/officeart/2005/8/layout/hierarchy1"/>
    <dgm:cxn modelId="{C6313A44-CB5C-444C-A955-0A5639F687B2}" type="presParOf" srcId="{CB4D576A-799F-41C9-BDD7-2C37900E3F62}" destId="{D5BB3744-2B46-453C-AC47-1F36676778C0}" srcOrd="2" destOrd="0" presId="urn:microsoft.com/office/officeart/2005/8/layout/hierarchy1"/>
    <dgm:cxn modelId="{51DD1B33-24F9-4CF8-A36E-D293B90FB5C1}" type="presParOf" srcId="{CB4D576A-799F-41C9-BDD7-2C37900E3F62}" destId="{734A4DD1-7DEA-41E2-A6BB-1CAE07FA11FC}" srcOrd="3" destOrd="0" presId="urn:microsoft.com/office/officeart/2005/8/layout/hierarchy1"/>
    <dgm:cxn modelId="{3156A2C5-4467-456F-9A0E-3F23F23A755E}" type="presParOf" srcId="{734A4DD1-7DEA-41E2-A6BB-1CAE07FA11FC}" destId="{7CB33730-FA30-4BC2-A131-D20363135DA7}" srcOrd="0" destOrd="0" presId="urn:microsoft.com/office/officeart/2005/8/layout/hierarchy1"/>
    <dgm:cxn modelId="{B0A1ABEF-298A-4120-8896-0FCB815795CB}" type="presParOf" srcId="{7CB33730-FA30-4BC2-A131-D20363135DA7}" destId="{14CA967C-69D4-4A31-A470-6E2727B7B863}" srcOrd="0" destOrd="0" presId="urn:microsoft.com/office/officeart/2005/8/layout/hierarchy1"/>
    <dgm:cxn modelId="{DA64148A-E15B-4983-B63A-D2D99B7B5C4E}" type="presParOf" srcId="{7CB33730-FA30-4BC2-A131-D20363135DA7}" destId="{1590B6B2-45F3-4970-9A5E-2DA85349EFA2}" srcOrd="1" destOrd="0" presId="urn:microsoft.com/office/officeart/2005/8/layout/hierarchy1"/>
    <dgm:cxn modelId="{CB81C7E6-ADA8-4813-BD77-FB4F737CD067}" type="presParOf" srcId="{734A4DD1-7DEA-41E2-A6BB-1CAE07FA11FC}" destId="{0008B24A-AB2B-4B09-83DF-36EA04EDFF83}" srcOrd="1" destOrd="0" presId="urn:microsoft.com/office/officeart/2005/8/layout/hierarchy1"/>
    <dgm:cxn modelId="{B76F901D-7402-492F-B690-5B3CC45916D3}" type="presParOf" srcId="{C878A5E7-A876-4033-8389-3DFBBCD9EF8E}" destId="{32596D3B-0780-40A8-9331-920867EBD6CE}" srcOrd="2" destOrd="0" presId="urn:microsoft.com/office/officeart/2005/8/layout/hierarchy1"/>
    <dgm:cxn modelId="{5D733C1B-E13E-494F-BD23-49274FB7875E}" type="presParOf" srcId="{C878A5E7-A876-4033-8389-3DFBBCD9EF8E}" destId="{B48C8F5D-3619-4E42-8055-4A31332A9E7D}" srcOrd="3" destOrd="0" presId="urn:microsoft.com/office/officeart/2005/8/layout/hierarchy1"/>
    <dgm:cxn modelId="{AD24C2E6-F4A4-4E73-BC80-C71186E0DB61}" type="presParOf" srcId="{B48C8F5D-3619-4E42-8055-4A31332A9E7D}" destId="{EB6A41EA-9DE9-4F61-876D-5C6AAB3E3FC5}" srcOrd="0" destOrd="0" presId="urn:microsoft.com/office/officeart/2005/8/layout/hierarchy1"/>
    <dgm:cxn modelId="{40F7C7DA-800C-4805-9650-405534754C30}" type="presParOf" srcId="{EB6A41EA-9DE9-4F61-876D-5C6AAB3E3FC5}" destId="{4770E6D1-52EA-44A5-BA54-563BCC195FBC}" srcOrd="0" destOrd="0" presId="urn:microsoft.com/office/officeart/2005/8/layout/hierarchy1"/>
    <dgm:cxn modelId="{179F800C-6E02-4C5B-A88D-F16EC05A8951}" type="presParOf" srcId="{EB6A41EA-9DE9-4F61-876D-5C6AAB3E3FC5}" destId="{06CF7725-2F70-42BB-864B-8B3DE6577B9A}" srcOrd="1" destOrd="0" presId="urn:microsoft.com/office/officeart/2005/8/layout/hierarchy1"/>
    <dgm:cxn modelId="{37F69A86-C8DC-4893-92E2-9AF81063BC53}" type="presParOf" srcId="{B48C8F5D-3619-4E42-8055-4A31332A9E7D}" destId="{B5B183A7-0C5A-48A2-A908-F67D462FF7B9}" srcOrd="1" destOrd="0" presId="urn:microsoft.com/office/officeart/2005/8/layout/hierarchy1"/>
    <dgm:cxn modelId="{0DECBC23-74A8-49EF-B255-6691B0B1EA19}" type="presParOf" srcId="{67E84683-E809-4B8E-9CF9-FE41C53733C7}" destId="{202B0CB6-3FA0-436A-88D5-42505860020F}" srcOrd="2" destOrd="0" presId="urn:microsoft.com/office/officeart/2005/8/layout/hierarchy1"/>
    <dgm:cxn modelId="{B0C4397C-F887-4EFD-A409-D3498EED8A5C}" type="presParOf" srcId="{67E84683-E809-4B8E-9CF9-FE41C53733C7}" destId="{ACB8F753-C3B2-4D4B-9058-944F59A9E605}" srcOrd="3" destOrd="0" presId="urn:microsoft.com/office/officeart/2005/8/layout/hierarchy1"/>
    <dgm:cxn modelId="{871815D2-F4DB-456E-BE34-3864774010D2}" type="presParOf" srcId="{ACB8F753-C3B2-4D4B-9058-944F59A9E605}" destId="{5F547329-2E88-47B4-9E9E-C6A75F5FEE14}" srcOrd="0" destOrd="0" presId="urn:microsoft.com/office/officeart/2005/8/layout/hierarchy1"/>
    <dgm:cxn modelId="{D497E949-E185-4B9A-B0DC-1347A0C23989}" type="presParOf" srcId="{5F547329-2E88-47B4-9E9E-C6A75F5FEE14}" destId="{C7CEE3C8-1FA0-4DFF-9ED9-BF9A56C6AB87}" srcOrd="0" destOrd="0" presId="urn:microsoft.com/office/officeart/2005/8/layout/hierarchy1"/>
    <dgm:cxn modelId="{E59DFC7B-6711-4BE9-9F41-5F07BB097A60}" type="presParOf" srcId="{5F547329-2E88-47B4-9E9E-C6A75F5FEE14}" destId="{74144E7D-812E-4D4C-82D5-A2D4E2824DB6}" srcOrd="1" destOrd="0" presId="urn:microsoft.com/office/officeart/2005/8/layout/hierarchy1"/>
    <dgm:cxn modelId="{B0EA4723-28D2-475B-81E6-E0B062A31CAA}" type="presParOf" srcId="{ACB8F753-C3B2-4D4B-9058-944F59A9E605}" destId="{C9045B60-3970-47F8-BA5B-40A60BDC833B}" srcOrd="1" destOrd="0" presId="urn:microsoft.com/office/officeart/2005/8/layout/hierarchy1"/>
    <dgm:cxn modelId="{9F49BEF3-5E27-4214-BD99-1BDE7C4F366A}" type="presParOf" srcId="{5A5B4A29-7964-4D65-ACAB-C6CB0A5058C5}" destId="{D11FC04E-96E8-4439-A3AA-3C45DB5E8B98}" srcOrd="2" destOrd="0" presId="urn:microsoft.com/office/officeart/2005/8/layout/hierarchy1"/>
    <dgm:cxn modelId="{F9285F4D-3490-4B78-A6A3-A2C05586F6E5}" type="presParOf" srcId="{5A5B4A29-7964-4D65-ACAB-C6CB0A5058C5}" destId="{2A5921DF-A20E-4FE5-83A1-BFD5D194D27F}" srcOrd="3" destOrd="0" presId="urn:microsoft.com/office/officeart/2005/8/layout/hierarchy1"/>
    <dgm:cxn modelId="{582497D7-D702-4465-B28F-CE1A6AB34469}" type="presParOf" srcId="{2A5921DF-A20E-4FE5-83A1-BFD5D194D27F}" destId="{7743D03E-DAB8-4207-8B24-B3D0B08FC6C7}" srcOrd="0" destOrd="0" presId="urn:microsoft.com/office/officeart/2005/8/layout/hierarchy1"/>
    <dgm:cxn modelId="{9A845D8A-A1F6-4A52-95E4-8CDF9A20827B}" type="presParOf" srcId="{7743D03E-DAB8-4207-8B24-B3D0B08FC6C7}" destId="{156384C0-5275-4249-B028-55B3A5BCD6E4}" srcOrd="0" destOrd="0" presId="urn:microsoft.com/office/officeart/2005/8/layout/hierarchy1"/>
    <dgm:cxn modelId="{064B48CB-109C-4A6D-8D79-07DEA4C4307F}" type="presParOf" srcId="{7743D03E-DAB8-4207-8B24-B3D0B08FC6C7}" destId="{6CC69C4C-5C4F-42E0-852D-8F4970DEDE63}" srcOrd="1" destOrd="0" presId="urn:microsoft.com/office/officeart/2005/8/layout/hierarchy1"/>
    <dgm:cxn modelId="{BE204EFE-1AE2-4CEB-820B-7529869BCB30}" type="presParOf" srcId="{2A5921DF-A20E-4FE5-83A1-BFD5D194D27F}" destId="{CBC3B056-6AD2-4138-A83D-6A01935052D6}" srcOrd="1" destOrd="0" presId="urn:microsoft.com/office/officeart/2005/8/layout/hierarchy1"/>
  </dgm:cxnLst>
  <dgm:bg>
    <a:effectLst/>
  </dgm:bg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11FC04E-96E8-4439-A3AA-3C45DB5E8B98}">
      <dsp:nvSpPr>
        <dsp:cNvPr id="0" name=""/>
        <dsp:cNvSpPr/>
      </dsp:nvSpPr>
      <dsp:spPr>
        <a:xfrm>
          <a:off x="4732228" y="1483332"/>
          <a:ext cx="1982990" cy="27791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48203"/>
              </a:lnTo>
              <a:lnTo>
                <a:pt x="2087195" y="248203"/>
              </a:lnTo>
              <a:lnTo>
                <a:pt x="2087195" y="364216"/>
              </a:lnTo>
            </a:path>
          </a:pathLst>
        </a:custGeom>
        <a:noFill/>
        <a:ln w="19050" cap="flat" cmpd="sng" algn="ctr">
          <a:solidFill>
            <a:srgbClr val="94B6D2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02B0CB6-3FA0-436A-88D5-42505860020F}">
      <dsp:nvSpPr>
        <dsp:cNvPr id="0" name=""/>
        <dsp:cNvSpPr/>
      </dsp:nvSpPr>
      <dsp:spPr>
        <a:xfrm>
          <a:off x="3407820" y="2348570"/>
          <a:ext cx="1906000" cy="41239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26606"/>
              </a:lnTo>
              <a:lnTo>
                <a:pt x="1888102" y="326606"/>
              </a:lnTo>
              <a:lnTo>
                <a:pt x="1888102" y="408521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2596D3B-0780-40A8-9331-920867EBD6CE}">
      <dsp:nvSpPr>
        <dsp:cNvPr id="0" name=""/>
        <dsp:cNvSpPr/>
      </dsp:nvSpPr>
      <dsp:spPr>
        <a:xfrm>
          <a:off x="2194850" y="3182236"/>
          <a:ext cx="850305" cy="34022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255111"/>
              </a:lnTo>
              <a:lnTo>
                <a:pt x="842321" y="255111"/>
              </a:lnTo>
              <a:lnTo>
                <a:pt x="842321" y="337026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5BB3744-2B46-453C-AC47-1F36676778C0}">
      <dsp:nvSpPr>
        <dsp:cNvPr id="0" name=""/>
        <dsp:cNvSpPr/>
      </dsp:nvSpPr>
      <dsp:spPr>
        <a:xfrm>
          <a:off x="1361026" y="4296673"/>
          <a:ext cx="727476" cy="25960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75250"/>
              </a:lnTo>
              <a:lnTo>
                <a:pt x="720645" y="175250"/>
              </a:lnTo>
              <a:lnTo>
                <a:pt x="720645" y="257165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7A7B80E-F6CC-48D8-8591-D6D8F8363A55}">
      <dsp:nvSpPr>
        <dsp:cNvPr id="0" name=""/>
        <dsp:cNvSpPr/>
      </dsp:nvSpPr>
      <dsp:spPr>
        <a:xfrm>
          <a:off x="660703" y="4296673"/>
          <a:ext cx="700323" cy="259603"/>
        </a:xfrm>
        <a:custGeom>
          <a:avLst/>
          <a:gdLst/>
          <a:ahLst/>
          <a:cxnLst/>
          <a:rect l="0" t="0" r="0" b="0"/>
          <a:pathLst>
            <a:path>
              <a:moveTo>
                <a:pt x="693747" y="0"/>
              </a:moveTo>
              <a:lnTo>
                <a:pt x="693747" y="175250"/>
              </a:lnTo>
              <a:lnTo>
                <a:pt x="0" y="175250"/>
              </a:lnTo>
              <a:lnTo>
                <a:pt x="0" y="257165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B8B08B8-D060-4959-AA49-49A2B88D57E9}">
      <dsp:nvSpPr>
        <dsp:cNvPr id="0" name=""/>
        <dsp:cNvSpPr/>
      </dsp:nvSpPr>
      <dsp:spPr>
        <a:xfrm>
          <a:off x="1361026" y="3182236"/>
          <a:ext cx="833823" cy="340221"/>
        </a:xfrm>
        <a:custGeom>
          <a:avLst/>
          <a:gdLst/>
          <a:ahLst/>
          <a:cxnLst/>
          <a:rect l="0" t="0" r="0" b="0"/>
          <a:pathLst>
            <a:path>
              <a:moveTo>
                <a:pt x="825993" y="0"/>
              </a:moveTo>
              <a:lnTo>
                <a:pt x="825993" y="255111"/>
              </a:lnTo>
              <a:lnTo>
                <a:pt x="0" y="255111"/>
              </a:lnTo>
              <a:lnTo>
                <a:pt x="0" y="337026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5286430-4C90-4FEE-AACD-7FB5EB372121}">
      <dsp:nvSpPr>
        <dsp:cNvPr id="0" name=""/>
        <dsp:cNvSpPr/>
      </dsp:nvSpPr>
      <dsp:spPr>
        <a:xfrm>
          <a:off x="2194850" y="2348570"/>
          <a:ext cx="1212970" cy="405059"/>
        </a:xfrm>
        <a:custGeom>
          <a:avLst/>
          <a:gdLst/>
          <a:ahLst/>
          <a:cxnLst/>
          <a:rect l="0" t="0" r="0" b="0"/>
          <a:pathLst>
            <a:path>
              <a:moveTo>
                <a:pt x="1201580" y="0"/>
              </a:moveTo>
              <a:lnTo>
                <a:pt x="1201580" y="319340"/>
              </a:lnTo>
              <a:lnTo>
                <a:pt x="0" y="319340"/>
              </a:lnTo>
              <a:lnTo>
                <a:pt x="0" y="401255"/>
              </a:lnTo>
            </a:path>
          </a:pathLst>
        </a:custGeom>
        <a:noFill/>
        <a:ln w="25400" cap="flat" cmpd="sng" algn="ctr">
          <a:solidFill>
            <a:srgbClr val="4F81BD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47A1D55-4DB3-4FDC-AECE-1082347F7737}">
      <dsp:nvSpPr>
        <dsp:cNvPr id="0" name=""/>
        <dsp:cNvSpPr/>
      </dsp:nvSpPr>
      <dsp:spPr>
        <a:xfrm>
          <a:off x="3407820" y="1483332"/>
          <a:ext cx="1324407" cy="337154"/>
        </a:xfrm>
        <a:custGeom>
          <a:avLst/>
          <a:gdLst/>
          <a:ahLst/>
          <a:cxnLst/>
          <a:rect l="0" t="0" r="0" b="0"/>
          <a:pathLst>
            <a:path>
              <a:moveTo>
                <a:pt x="885561" y="0"/>
              </a:moveTo>
              <a:lnTo>
                <a:pt x="885561" y="248203"/>
              </a:lnTo>
              <a:lnTo>
                <a:pt x="0" y="248203"/>
              </a:lnTo>
              <a:lnTo>
                <a:pt x="0" y="364216"/>
              </a:lnTo>
            </a:path>
          </a:pathLst>
        </a:custGeom>
        <a:noFill/>
        <a:ln w="19050" cap="flat" cmpd="sng" algn="ctr">
          <a:solidFill>
            <a:srgbClr val="94B6D2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387A3BD-E809-4CAF-9267-D6EE374FCD98}">
      <dsp:nvSpPr>
        <dsp:cNvPr id="0" name=""/>
        <dsp:cNvSpPr/>
      </dsp:nvSpPr>
      <dsp:spPr>
        <a:xfrm>
          <a:off x="4686508" y="920562"/>
          <a:ext cx="91440" cy="170891"/>
        </a:xfrm>
        <a:custGeom>
          <a:avLst/>
          <a:gdLst/>
          <a:ahLst/>
          <a:cxnLst/>
          <a:rect l="0" t="0" r="0" b="0"/>
          <a:pathLst>
            <a:path>
              <a:moveTo>
                <a:pt x="77375" y="0"/>
              </a:moveTo>
              <a:lnTo>
                <a:pt x="77375" y="87372"/>
              </a:lnTo>
              <a:lnTo>
                <a:pt x="45720" y="87372"/>
              </a:lnTo>
              <a:lnTo>
                <a:pt x="45720" y="169286"/>
              </a:lnTo>
            </a:path>
          </a:pathLst>
        </a:custGeom>
        <a:noFill/>
        <a:ln w="19050" cap="flat" cmpd="sng" algn="ctr">
          <a:solidFill>
            <a:srgbClr val="94B6D2">
              <a:shade val="8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B44A5C3-2C93-4DB5-9727-C467EB26B818}">
      <dsp:nvSpPr>
        <dsp:cNvPr id="0" name=""/>
        <dsp:cNvSpPr/>
      </dsp:nvSpPr>
      <dsp:spPr>
        <a:xfrm>
          <a:off x="4711430" y="349673"/>
          <a:ext cx="91440" cy="14167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71543"/>
              </a:lnTo>
              <a:lnTo>
                <a:pt x="52687" y="71543"/>
              </a:lnTo>
              <a:lnTo>
                <a:pt x="52687" y="153458"/>
              </a:lnTo>
            </a:path>
          </a:pathLst>
        </a:custGeom>
        <a:noFill/>
        <a:ln w="19050" cap="flat" cmpd="sng" algn="ctr">
          <a:solidFill>
            <a:srgbClr val="94B6D2">
              <a:shade val="60000"/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116B23F-6F26-4772-A1FD-AE5086DCB5B7}">
      <dsp:nvSpPr>
        <dsp:cNvPr id="0" name=""/>
        <dsp:cNvSpPr/>
      </dsp:nvSpPr>
      <dsp:spPr>
        <a:xfrm>
          <a:off x="3447507" y="-94220"/>
          <a:ext cx="2619284" cy="443894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E20AF85-4737-4C95-907B-1CE481DCF68E}">
      <dsp:nvSpPr>
        <dsp:cNvPr id="0" name=""/>
        <dsp:cNvSpPr/>
      </dsp:nvSpPr>
      <dsp:spPr>
        <a:xfrm>
          <a:off x="3546687" y="0"/>
          <a:ext cx="2619284" cy="443894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lvl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5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525</a:t>
          </a:r>
          <a:r>
            <a:rPr lang="en-US" sz="105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records identified after database  search</a:t>
          </a:r>
          <a:endParaRPr lang="en-US" sz="105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3559688" y="13001"/>
        <a:ext cx="2593282" cy="417892"/>
      </dsp:txXfrm>
    </dsp:sp>
    <dsp:sp modelId="{01DF9809-8EBA-42BA-8D79-9B12B2DC7BAC}">
      <dsp:nvSpPr>
        <dsp:cNvPr id="0" name=""/>
        <dsp:cNvSpPr/>
      </dsp:nvSpPr>
      <dsp:spPr>
        <a:xfrm>
          <a:off x="3553359" y="491349"/>
          <a:ext cx="2421649" cy="429213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6485CEB-AFB9-41C8-B562-3BD3309E36DD}">
      <dsp:nvSpPr>
        <dsp:cNvPr id="0" name=""/>
        <dsp:cNvSpPr/>
      </dsp:nvSpPr>
      <dsp:spPr>
        <a:xfrm>
          <a:off x="3652538" y="585570"/>
          <a:ext cx="2421649" cy="429213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lvl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5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368</a:t>
          </a:r>
          <a:r>
            <a:rPr lang="en-US" sz="105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records after duplicates are removed</a:t>
          </a:r>
          <a:endParaRPr lang="en-US" sz="105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3665109" y="598141"/>
        <a:ext cx="2396507" cy="404071"/>
      </dsp:txXfrm>
    </dsp:sp>
    <dsp:sp modelId="{7AD82E37-BF6E-4FB2-943B-0960A5A09FF4}">
      <dsp:nvSpPr>
        <dsp:cNvPr id="0" name=""/>
        <dsp:cNvSpPr/>
      </dsp:nvSpPr>
      <dsp:spPr>
        <a:xfrm>
          <a:off x="3688291" y="1091454"/>
          <a:ext cx="2087872" cy="391877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802892D-E7D3-45B3-99E9-CD182AF787F9}">
      <dsp:nvSpPr>
        <dsp:cNvPr id="0" name=""/>
        <dsp:cNvSpPr/>
      </dsp:nvSpPr>
      <dsp:spPr>
        <a:xfrm>
          <a:off x="3787471" y="1185675"/>
          <a:ext cx="2087872" cy="391877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lvl="0" algn="ctr" defTabSz="466725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5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records screened for relevance</a:t>
          </a:r>
          <a:endParaRPr lang="en-US" sz="105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3798949" y="1197153"/>
        <a:ext cx="2064916" cy="368921"/>
      </dsp:txXfrm>
    </dsp:sp>
    <dsp:sp modelId="{C7CD2683-6E39-4465-A73B-0C63C02BF058}">
      <dsp:nvSpPr>
        <dsp:cNvPr id="0" name=""/>
        <dsp:cNvSpPr/>
      </dsp:nvSpPr>
      <dsp:spPr>
        <a:xfrm>
          <a:off x="1403131" y="1820487"/>
          <a:ext cx="4009378" cy="528082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79B0968-FA09-4E45-A053-819CCA6DC639}">
      <dsp:nvSpPr>
        <dsp:cNvPr id="0" name=""/>
        <dsp:cNvSpPr/>
      </dsp:nvSpPr>
      <dsp:spPr>
        <a:xfrm>
          <a:off x="1502311" y="1914708"/>
          <a:ext cx="4009378" cy="528082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51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full text articles assessed for eligibility by 2 independent reviewers (MA &amp; HE)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A third investigator resolved any conflicts (DL)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1517778" y="1930175"/>
        <a:ext cx="3978444" cy="497148"/>
      </dsp:txXfrm>
    </dsp:sp>
    <dsp:sp modelId="{9B35C26D-65AA-4C58-A96F-A40DAC36E166}">
      <dsp:nvSpPr>
        <dsp:cNvPr id="0" name=""/>
        <dsp:cNvSpPr/>
      </dsp:nvSpPr>
      <dsp:spPr>
        <a:xfrm>
          <a:off x="1403730" y="2753629"/>
          <a:ext cx="1582239" cy="428607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9CE802F-B065-4598-AA01-C44FF0888C18}">
      <dsp:nvSpPr>
        <dsp:cNvPr id="0" name=""/>
        <dsp:cNvSpPr/>
      </dsp:nvSpPr>
      <dsp:spPr>
        <a:xfrm>
          <a:off x="1502910" y="2847850"/>
          <a:ext cx="1582239" cy="428607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31 studies reviewed for potential inclusion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1515463" y="2860403"/>
        <a:ext cx="1557133" cy="403501"/>
      </dsp:txXfrm>
    </dsp:sp>
    <dsp:sp modelId="{80D99166-3740-4EE8-A9EB-0CB301DB7ECF}">
      <dsp:nvSpPr>
        <dsp:cNvPr id="0" name=""/>
        <dsp:cNvSpPr/>
      </dsp:nvSpPr>
      <dsp:spPr>
        <a:xfrm>
          <a:off x="614007" y="3522457"/>
          <a:ext cx="1494039" cy="774216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C4195F0-9177-41EC-88F9-2C0B5A67BF91}">
      <dsp:nvSpPr>
        <dsp:cNvPr id="0" name=""/>
        <dsp:cNvSpPr/>
      </dsp:nvSpPr>
      <dsp:spPr>
        <a:xfrm>
          <a:off x="713186" y="3616678"/>
          <a:ext cx="1494039" cy="774216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23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studies underwent quality assessment using QUADAS 2 tool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(diagnostic performance)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735862" y="3639354"/>
        <a:ext cx="1448687" cy="728864"/>
      </dsp:txXfrm>
    </dsp:sp>
    <dsp:sp modelId="{1EE4E8A7-BBE9-46D6-98D9-D4D857401239}">
      <dsp:nvSpPr>
        <dsp:cNvPr id="0" name=""/>
        <dsp:cNvSpPr/>
      </dsp:nvSpPr>
      <dsp:spPr>
        <a:xfrm>
          <a:off x="32406" y="4556277"/>
          <a:ext cx="1256593" cy="724869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3DF8DF5-0AF7-4543-BEA4-199F24156AED}">
      <dsp:nvSpPr>
        <dsp:cNvPr id="0" name=""/>
        <dsp:cNvSpPr/>
      </dsp:nvSpPr>
      <dsp:spPr>
        <a:xfrm>
          <a:off x="131586" y="4650498"/>
          <a:ext cx="1256593" cy="724869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Group A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13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studies included in the meta analysis  for </a:t>
          </a: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diagnostic accuracy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152817" y="4671729"/>
        <a:ext cx="1214131" cy="682407"/>
      </dsp:txXfrm>
    </dsp:sp>
    <dsp:sp modelId="{14CA967C-69D4-4A31-A470-6E2727B7B863}">
      <dsp:nvSpPr>
        <dsp:cNvPr id="0" name=""/>
        <dsp:cNvSpPr/>
      </dsp:nvSpPr>
      <dsp:spPr>
        <a:xfrm>
          <a:off x="1487360" y="4556277"/>
          <a:ext cx="1202286" cy="566813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590B6B2-45F3-4970-9A5E-2DA85349EFA2}">
      <dsp:nvSpPr>
        <dsp:cNvPr id="0" name=""/>
        <dsp:cNvSpPr/>
      </dsp:nvSpPr>
      <dsp:spPr>
        <a:xfrm>
          <a:off x="1586540" y="4650498"/>
          <a:ext cx="1202286" cy="566813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w Cen MT"/>
              <a:ea typeface="+mn-ea"/>
              <a:cs typeface="+mn-cs"/>
            </a:rPr>
            <a:t>Group C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w Cen MT"/>
              <a:ea typeface="+mn-ea"/>
              <a:cs typeface="+mn-cs"/>
            </a:rPr>
            <a:t>10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Tw Cen MT"/>
              <a:ea typeface="+mn-ea"/>
              <a:cs typeface="+mn-cs"/>
            </a:rPr>
            <a:t> studies incomplete patient level data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1603141" y="4667099"/>
        <a:ext cx="1169084" cy="533611"/>
      </dsp:txXfrm>
    </dsp:sp>
    <dsp:sp modelId="{4770E6D1-52EA-44A5-BA54-563BCC195FBC}">
      <dsp:nvSpPr>
        <dsp:cNvPr id="0" name=""/>
        <dsp:cNvSpPr/>
      </dsp:nvSpPr>
      <dsp:spPr>
        <a:xfrm>
          <a:off x="2306406" y="3522457"/>
          <a:ext cx="1477499" cy="653246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6CF7725-2F70-42BB-864B-8B3DE6577B9A}">
      <dsp:nvSpPr>
        <dsp:cNvPr id="0" name=""/>
        <dsp:cNvSpPr/>
      </dsp:nvSpPr>
      <dsp:spPr>
        <a:xfrm>
          <a:off x="2405586" y="3616678"/>
          <a:ext cx="1477499" cy="653246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Group B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8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 studies for assessment of </a:t>
          </a: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prognostic performance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2424719" y="3635811"/>
        <a:ext cx="1439233" cy="614980"/>
      </dsp:txXfrm>
    </dsp:sp>
    <dsp:sp modelId="{C7CEE3C8-1FA0-4DFF-9ED9-BF9A56C6AB87}">
      <dsp:nvSpPr>
        <dsp:cNvPr id="0" name=""/>
        <dsp:cNvSpPr/>
      </dsp:nvSpPr>
      <dsp:spPr>
        <a:xfrm>
          <a:off x="3853772" y="2760963"/>
          <a:ext cx="2920097" cy="770390"/>
        </a:xfrm>
        <a:prstGeom prst="roundRect">
          <a:avLst>
            <a:gd name="adj" fmla="val 10000"/>
          </a:avLst>
        </a:prstGeom>
        <a:solidFill>
          <a:srgbClr val="4F81BD">
            <a:hueOff val="0"/>
            <a:satOff val="0"/>
            <a:lumOff val="0"/>
            <a:alphaOff val="0"/>
          </a:srgbClr>
        </a:solidFill>
        <a:ln w="2540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4144E7D-812E-4D4C-82D5-A2D4E2824DB6}">
      <dsp:nvSpPr>
        <dsp:cNvPr id="0" name=""/>
        <dsp:cNvSpPr/>
      </dsp:nvSpPr>
      <dsp:spPr>
        <a:xfrm>
          <a:off x="3952952" y="2855184"/>
          <a:ext cx="2920097" cy="770390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25400" cap="flat" cmpd="sng" algn="ctr">
          <a:solidFill>
            <a:srgbClr val="4F81BD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8100" tIns="38100" rIns="38100" bIns="38100" numCol="1" spcCol="1270" anchor="ctr" anchorCtr="0">
          <a:noAutofit/>
        </a:bodyPr>
        <a:lstStyle/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Group Z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:  20 full text articles excluded because</a:t>
          </a:r>
          <a:r>
            <a:rPr lang="en-US" sz="1000" b="1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: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- incomplete anatomic or outcome data (n=16)</a:t>
          </a:r>
        </a:p>
        <a:p>
          <a:pPr lvl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- no methodology described for TID assessment (n=5)</a:t>
          </a:r>
          <a:endParaRPr lang="en-US" sz="10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3975516" y="2877748"/>
        <a:ext cx="2874969" cy="725262"/>
      </dsp:txXfrm>
    </dsp:sp>
    <dsp:sp modelId="{156384C0-5275-4249-B028-55B3A5BCD6E4}">
      <dsp:nvSpPr>
        <dsp:cNvPr id="0" name=""/>
        <dsp:cNvSpPr/>
      </dsp:nvSpPr>
      <dsp:spPr>
        <a:xfrm>
          <a:off x="6187680" y="1761249"/>
          <a:ext cx="1055076" cy="544072"/>
        </a:xfrm>
        <a:prstGeom prst="roundRect">
          <a:avLst>
            <a:gd name="adj" fmla="val 10000"/>
          </a:avLst>
        </a:prstGeom>
        <a:solidFill>
          <a:srgbClr val="4F81BD"/>
        </a:solidFill>
        <a:ln w="19050" cap="flat" cmpd="sng" algn="ctr">
          <a:solidFill>
            <a:sysClr val="window" lastClr="FFFFFF">
              <a:hueOff val="0"/>
              <a:satOff val="0"/>
              <a:lumOff val="0"/>
              <a:alphaOff val="0"/>
            </a:sys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CC69C4C-5C4F-42E0-852D-8F4970DEDE63}">
      <dsp:nvSpPr>
        <dsp:cNvPr id="0" name=""/>
        <dsp:cNvSpPr/>
      </dsp:nvSpPr>
      <dsp:spPr>
        <a:xfrm>
          <a:off x="6286860" y="1855470"/>
          <a:ext cx="1055076" cy="544072"/>
        </a:xfrm>
        <a:prstGeom prst="roundRect">
          <a:avLst>
            <a:gd name="adj" fmla="val 10000"/>
          </a:avLst>
        </a:prstGeom>
        <a:solidFill>
          <a:sysClr val="window" lastClr="FFFFFF">
            <a:alpha val="90000"/>
            <a:hueOff val="0"/>
            <a:satOff val="0"/>
            <a:lumOff val="0"/>
            <a:alphaOff val="0"/>
          </a:sysClr>
        </a:solidFill>
        <a:ln w="19050" cap="flat" cmpd="sng" algn="ctr">
          <a:solidFill>
            <a:srgbClr val="94B6D2">
              <a:hueOff val="0"/>
              <a:satOff val="0"/>
              <a:lumOff val="0"/>
              <a:alphaOff val="0"/>
            </a:srgb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400" kern="12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400" kern="12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000" kern="12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000" kern="120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317 </a:t>
          </a:r>
          <a:r>
            <a:rPr lang="en-US" sz="1000" kern="1200" dirty="0" smtClean="0">
              <a:solidFill>
                <a:sysClr val="windowText" lastClr="000000">
                  <a:hueOff val="0"/>
                  <a:satOff val="0"/>
                  <a:lumOff val="0"/>
                  <a:alphaOff val="0"/>
                </a:sysClr>
              </a:solidFill>
              <a:latin typeface="Calibri"/>
              <a:ea typeface="+mn-ea"/>
              <a:cs typeface="+mn-cs"/>
            </a:rPr>
            <a:t>records excluded</a:t>
          </a:r>
        </a:p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400" kern="12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lvl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400" kern="1200" dirty="0" smtClean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400" kern="1200" dirty="0">
            <a:solidFill>
              <a:sysClr val="windowText" lastClr="000000">
                <a:hueOff val="0"/>
                <a:satOff val="0"/>
                <a:lumOff val="0"/>
                <a:alphaOff val="0"/>
              </a:sysClr>
            </a:solidFill>
            <a:latin typeface="Calibri"/>
            <a:ea typeface="+mn-ea"/>
            <a:cs typeface="+mn-cs"/>
          </a:endParaRPr>
        </a:p>
      </dsp:txBody>
      <dsp:txXfrm>
        <a:off x="6302795" y="1871405"/>
        <a:ext cx="1023206" cy="51220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017-05-2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4" Type="http://schemas.openxmlformats.org/officeDocument/2006/relationships/image" Target="../media/image7.tiff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tif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219200"/>
            <a:ext cx="7772400" cy="1470025"/>
          </a:xfrm>
        </p:spPr>
        <p:txBody>
          <a:bodyPr>
            <a:noAutofit/>
          </a:bodyPr>
          <a:lstStyle/>
          <a:p>
            <a:r>
              <a:rPr lang="en-US" sz="3200" b="1" dirty="0" smtClean="0"/>
              <a:t>Diagnostic and Prognostic Significance of Transient Ischemic Dilation (TID) in Myocardial Perfusion Imaging: A Systematic Review and Meta-Analysis</a:t>
            </a:r>
            <a:endParaRPr lang="en-US" sz="3200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8200" y="3460997"/>
            <a:ext cx="7467600" cy="1752600"/>
          </a:xfrm>
        </p:spPr>
        <p:txBody>
          <a:bodyPr>
            <a:normAutofit/>
          </a:bodyPr>
          <a:lstStyle/>
          <a:p>
            <a:r>
              <a:rPr lang="en-US" sz="2000" dirty="0"/>
              <a:t>Mohamed </a:t>
            </a:r>
            <a:r>
              <a:rPr lang="en-US" sz="2000" dirty="0" err="1"/>
              <a:t>Alama</a:t>
            </a:r>
            <a:r>
              <a:rPr lang="en-US" sz="2000" dirty="0"/>
              <a:t> MBBCH </a:t>
            </a:r>
            <a:r>
              <a:rPr lang="en-US" sz="2000" dirty="0" smtClean="0"/>
              <a:t>MSc, </a:t>
            </a:r>
            <a:r>
              <a:rPr lang="en-US" sz="2000" dirty="0"/>
              <a:t>Christopher </a:t>
            </a:r>
            <a:r>
              <a:rPr lang="en-US" sz="2000" dirty="0" err="1"/>
              <a:t>Labos</a:t>
            </a:r>
            <a:r>
              <a:rPr lang="en-US" sz="2000" dirty="0"/>
              <a:t> MDCM MSc</a:t>
            </a:r>
            <a:r>
              <a:rPr lang="en-US" sz="2000" dirty="0" smtClean="0"/>
              <a:t>,</a:t>
            </a:r>
            <a:r>
              <a:rPr lang="en-CA" sz="2000" dirty="0"/>
              <a:t> </a:t>
            </a:r>
            <a:endParaRPr lang="en-CA" sz="2000" dirty="0" smtClean="0"/>
          </a:p>
          <a:p>
            <a:r>
              <a:rPr lang="en-US" sz="2000" dirty="0" smtClean="0"/>
              <a:t>Handel </a:t>
            </a:r>
            <a:r>
              <a:rPr lang="en-US" sz="2000" dirty="0"/>
              <a:t>Emery MBBS </a:t>
            </a:r>
            <a:r>
              <a:rPr lang="en-US" sz="2000" dirty="0" smtClean="0"/>
              <a:t>DM, </a:t>
            </a:r>
            <a:r>
              <a:rPr lang="en-US" sz="2000" dirty="0"/>
              <a:t>Robert M. </a:t>
            </a:r>
            <a:r>
              <a:rPr lang="en-US" sz="2000" dirty="0" err="1"/>
              <a:t>Iwanochko</a:t>
            </a:r>
            <a:r>
              <a:rPr lang="en-US" sz="2000" dirty="0"/>
              <a:t> MD, </a:t>
            </a:r>
            <a:endParaRPr lang="en-US" sz="2000" dirty="0" smtClean="0"/>
          </a:p>
          <a:p>
            <a:r>
              <a:rPr lang="en-US" sz="2000" dirty="0" smtClean="0"/>
              <a:t>Michael </a:t>
            </a:r>
            <a:r>
              <a:rPr lang="en-US" sz="2000" dirty="0"/>
              <a:t>Freeman MD, </a:t>
            </a:r>
            <a:r>
              <a:rPr lang="en-US" sz="2000" dirty="0" err="1"/>
              <a:t>Mansoor</a:t>
            </a:r>
            <a:r>
              <a:rPr lang="en-US" sz="2000" dirty="0"/>
              <a:t> Husain MD, Douglas S. Lee MD PhD</a:t>
            </a:r>
            <a:endParaRPr lang="en-CA" sz="2000" dirty="0"/>
          </a:p>
          <a:p>
            <a:endParaRPr lang="en-US" dirty="0"/>
          </a:p>
        </p:txBody>
      </p:sp>
      <p:pic>
        <p:nvPicPr>
          <p:cNvPr id="4" name="Picture 3" descr="pmcc_uhn_LOGO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5486400"/>
            <a:ext cx="3433763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7800" y="5486400"/>
            <a:ext cx="3436938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398915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clusions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TID is a specific marker for detection of severe and extensive CAD</a:t>
            </a:r>
          </a:p>
          <a:p>
            <a:endParaRPr lang="en-US" sz="1200" dirty="0" smtClean="0"/>
          </a:p>
          <a:p>
            <a:r>
              <a:rPr lang="en-US" dirty="0" smtClean="0"/>
              <a:t>Presence of TID has high discrimination for detection of severe and extensive CAD</a:t>
            </a:r>
          </a:p>
          <a:p>
            <a:endParaRPr lang="en-US" sz="1200" dirty="0" smtClean="0"/>
          </a:p>
          <a:p>
            <a:r>
              <a:rPr lang="en-US" dirty="0" smtClean="0"/>
              <a:t>TID is an indicator of poor prognosis in those with ischemia or normal perfusion and DM or evidence suggestive of CA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57970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Background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TID is a potential marker of high risk obstructive coronary artery disease (CAD) on stress MPI </a:t>
            </a:r>
          </a:p>
          <a:p>
            <a:r>
              <a:rPr lang="en-US" dirty="0" smtClean="0"/>
              <a:t>However, there is variation in the literature regarding: </a:t>
            </a:r>
          </a:p>
          <a:p>
            <a:pPr lvl="1"/>
            <a:r>
              <a:rPr lang="en-US" dirty="0"/>
              <a:t>D</a:t>
            </a:r>
            <a:r>
              <a:rPr lang="en-US" dirty="0" smtClean="0"/>
              <a:t>iagnostic performance of TID for identification of severe and extensive CAD </a:t>
            </a:r>
          </a:p>
          <a:p>
            <a:pPr lvl="1"/>
            <a:r>
              <a:rPr lang="en-US" dirty="0" smtClean="0"/>
              <a:t>Prognostic implication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37467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Objectiv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 smtClean="0"/>
          </a:p>
          <a:p>
            <a:r>
              <a:rPr lang="en-US" dirty="0" smtClean="0"/>
              <a:t>To </a:t>
            </a:r>
            <a:r>
              <a:rPr lang="en-US" dirty="0"/>
              <a:t>perform a meta-analysis of diagnostic performance of TID compared to anatomical CAD </a:t>
            </a:r>
            <a:r>
              <a:rPr lang="en-US" dirty="0" smtClean="0"/>
              <a:t>assessment</a:t>
            </a:r>
          </a:p>
          <a:p>
            <a:endParaRPr lang="en-US" dirty="0"/>
          </a:p>
          <a:p>
            <a:r>
              <a:rPr lang="en-US" dirty="0"/>
              <a:t>To conduct a systematic review of the prognostic significance of TI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46375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Method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earch of MEDLINE, EMBASE and COCHRANE databases for studies comparing TID with invasive or CT coronary </a:t>
            </a:r>
            <a:r>
              <a:rPr lang="en-US" dirty="0" smtClean="0"/>
              <a:t>angiography</a:t>
            </a:r>
          </a:p>
          <a:p>
            <a:endParaRPr lang="en-US" dirty="0"/>
          </a:p>
          <a:p>
            <a:r>
              <a:rPr lang="en-US" dirty="0"/>
              <a:t>Sensitivity and specificity estimates pooled as recommended by the Cochrane Diagnostic Test Accuracy Working </a:t>
            </a:r>
            <a:r>
              <a:rPr lang="en-US" dirty="0" smtClean="0"/>
              <a:t>Grou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993821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>
            <p:extLst>
              <p:ext uri="{D42A27DB-BD31-4B8C-83A1-F6EECF244321}">
                <p14:modId xmlns:p14="http://schemas.microsoft.com/office/powerpoint/2010/main" val="4198272908"/>
              </p:ext>
            </p:extLst>
          </p:nvPr>
        </p:nvGraphicFramePr>
        <p:xfrm>
          <a:off x="762000" y="762000"/>
          <a:ext cx="7495222" cy="537813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257800" y="5257800"/>
            <a:ext cx="323992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Total # patients:</a:t>
            </a:r>
          </a:p>
          <a:p>
            <a:r>
              <a:rPr lang="en-US" dirty="0" smtClean="0"/>
              <a:t>2037 in diagnostic meta-analysis</a:t>
            </a:r>
          </a:p>
          <a:p>
            <a:r>
              <a:rPr lang="en-US" dirty="0" smtClean="0"/>
              <a:t>9003 in prognostic studies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919605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639306"/>
            <a:ext cx="8555843" cy="6218694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>
            <a:noAutofit/>
          </a:bodyPr>
          <a:lstStyle/>
          <a:p>
            <a:r>
              <a:rPr lang="en-US" sz="3600" dirty="0" smtClean="0"/>
              <a:t>Reports of Diagnostic Performance of TID</a:t>
            </a: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3218777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ROC curve.jpe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762000"/>
            <a:ext cx="6096000" cy="6096000"/>
          </a:xfrm>
          <a:prstGeom prst="rect">
            <a:avLst/>
          </a:prstGeom>
        </p:spPr>
      </p:pic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457200" y="31672"/>
            <a:ext cx="8229600" cy="1143000"/>
          </a:xfrm>
        </p:spPr>
        <p:txBody>
          <a:bodyPr/>
          <a:lstStyle/>
          <a:p>
            <a:r>
              <a:rPr lang="en-US" dirty="0" smtClean="0"/>
              <a:t>ROC Curve for TID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629400" y="2438400"/>
            <a:ext cx="1908019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pecificity 88%</a:t>
            </a:r>
          </a:p>
          <a:p>
            <a:r>
              <a:rPr lang="en-US" dirty="0" smtClean="0"/>
              <a:t>(95%CI; 83-92%)</a:t>
            </a:r>
          </a:p>
          <a:p>
            <a:endParaRPr lang="en-US" dirty="0"/>
          </a:p>
          <a:p>
            <a:r>
              <a:rPr lang="en-US" b="1" dirty="0" smtClean="0"/>
              <a:t>AUC 0.82</a:t>
            </a:r>
          </a:p>
          <a:p>
            <a:r>
              <a:rPr lang="en-US" dirty="0" smtClean="0"/>
              <a:t>(95%CI; 0.78-0.85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6085294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/>
          <a:lstStyle/>
          <a:p>
            <a:r>
              <a:rPr lang="en-US" dirty="0" smtClean="0"/>
              <a:t>Subgroup Analyses</a:t>
            </a:r>
            <a:endParaRPr lang="en-US" dirty="0"/>
          </a:p>
        </p:txBody>
      </p:sp>
      <p:pic>
        <p:nvPicPr>
          <p:cNvPr id="6" name="Picture 5" descr="exercise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1858962"/>
            <a:ext cx="2771776" cy="2771775"/>
          </a:xfrm>
          <a:prstGeom prst="rect">
            <a:avLst/>
          </a:prstGeom>
        </p:spPr>
      </p:pic>
      <p:pic>
        <p:nvPicPr>
          <p:cNvPr id="10" name="Picture 9" descr="pharm.ti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4537" y="1866899"/>
            <a:ext cx="2755900" cy="2755900"/>
          </a:xfrm>
          <a:prstGeom prst="rect">
            <a:avLst/>
          </a:prstGeom>
        </p:spPr>
      </p:pic>
      <p:pic>
        <p:nvPicPr>
          <p:cNvPr id="11" name="Picture 10" descr="tech.tif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24599" y="1866899"/>
            <a:ext cx="2755900" cy="27559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143000" y="1676400"/>
            <a:ext cx="938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xercise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962400" y="1600200"/>
            <a:ext cx="1724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harmacological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239000" y="1524000"/>
            <a:ext cx="1280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echnetiu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5039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2736864"/>
              </p:ext>
            </p:extLst>
          </p:nvPr>
        </p:nvGraphicFramePr>
        <p:xfrm>
          <a:off x="4953000" y="2057400"/>
          <a:ext cx="4030134" cy="35898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 rot="16200000">
            <a:off x="-1002577" y="3517178"/>
            <a:ext cx="2831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V death or MI (Annualized)</a:t>
            </a:r>
            <a:endParaRPr lang="en-US" dirty="0"/>
          </a:p>
        </p:txBody>
      </p:sp>
      <p:grpSp>
        <p:nvGrpSpPr>
          <p:cNvPr id="19" name="Group 18"/>
          <p:cNvGrpSpPr/>
          <p:nvPr/>
        </p:nvGrpSpPr>
        <p:grpSpPr>
          <a:xfrm>
            <a:off x="478301" y="1447800"/>
            <a:ext cx="8339797" cy="4657130"/>
            <a:chOff x="457200" y="990600"/>
            <a:chExt cx="8339797" cy="4657130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05460300"/>
                </p:ext>
              </p:extLst>
            </p:nvPr>
          </p:nvGraphicFramePr>
          <p:xfrm>
            <a:off x="546097" y="1642533"/>
            <a:ext cx="4080935" cy="35729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 rot="16200000">
              <a:off x="3389272" y="3059978"/>
              <a:ext cx="283168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CV death or MI (Annualized)</a:t>
              </a:r>
              <a:endParaRPr 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143000" y="4724400"/>
              <a:ext cx="8397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/>
                <a:t>Abidov</a:t>
              </a:r>
              <a:endParaRPr 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86000" y="4724400"/>
              <a:ext cx="8840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/>
                <a:t>Doukky</a:t>
              </a:r>
              <a:endParaRPr 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429000" y="4724400"/>
              <a:ext cx="9483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/>
                <a:t>Petretta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562600" y="4724400"/>
              <a:ext cx="8840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/>
                <a:t>Doukky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705600" y="4724400"/>
              <a:ext cx="948397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Petretta</a:t>
              </a:r>
              <a:endParaRPr lang="en-US" dirty="0" smtClean="0"/>
            </a:p>
            <a:p>
              <a:pPr algn="ctr"/>
              <a:r>
                <a:rPr lang="en-US" dirty="0" smtClean="0"/>
                <a:t>LVEF</a:t>
              </a:r>
            </a:p>
            <a:p>
              <a:pPr algn="ctr"/>
              <a:r>
                <a:rPr lang="en-US" dirty="0" smtClean="0"/>
                <a:t>&gt;45%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848600" y="4724400"/>
              <a:ext cx="948397" cy="9233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/>
                <a:t>Petretta</a:t>
              </a:r>
              <a:endParaRPr lang="en-US" dirty="0" smtClean="0"/>
            </a:p>
            <a:p>
              <a:pPr algn="ctr"/>
              <a:r>
                <a:rPr lang="en-US" dirty="0" smtClean="0"/>
                <a:t>LVEF</a:t>
              </a:r>
            </a:p>
            <a:p>
              <a:pPr algn="ctr"/>
              <a:r>
                <a:rPr lang="en-US" dirty="0" smtClean="0"/>
                <a:t>≤45%</a:t>
              </a:r>
              <a:endParaRPr lang="en-US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57200" y="990600"/>
              <a:ext cx="242942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/>
                <a:t>Normal Perfusion</a:t>
              </a:r>
              <a:endParaRPr lang="en-US" sz="24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876800" y="990600"/>
              <a:ext cx="35487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 smtClean="0"/>
                <a:t>Diabetes, CAD or Ischemia</a:t>
              </a:r>
              <a:endParaRPr lang="en-US" sz="2400" b="1" dirty="0"/>
            </a:p>
          </p:txBody>
        </p:sp>
      </p:grpSp>
      <p:sp>
        <p:nvSpPr>
          <p:cNvPr id="20" name="Title 19"/>
          <p:cNvSpPr>
            <a:spLocks noGrp="1"/>
          </p:cNvSpPr>
          <p:nvPr>
            <p:ph type="title"/>
          </p:nvPr>
        </p:nvSpPr>
        <p:spPr>
          <a:xfrm>
            <a:off x="533400" y="15240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TID and Prognosis</a:t>
            </a:r>
            <a:br>
              <a:rPr lang="en-US" dirty="0" smtClean="0"/>
            </a:br>
            <a:r>
              <a:rPr lang="en-US" sz="3100" dirty="0" smtClean="0"/>
              <a:t>CV death or MI</a:t>
            </a:r>
            <a:endParaRPr lang="en-US" sz="3100" dirty="0"/>
          </a:p>
        </p:txBody>
      </p:sp>
    </p:spTree>
    <p:extLst>
      <p:ext uri="{BB962C8B-B14F-4D97-AF65-F5344CB8AC3E}">
        <p14:creationId xmlns:p14="http://schemas.microsoft.com/office/powerpoint/2010/main" val="2234686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4</TotalTime>
  <Words>425</Words>
  <Application>Microsoft Macintosh PowerPoint</Application>
  <PresentationFormat>On-screen Show (4:3)</PresentationFormat>
  <Paragraphs>75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Diagnostic and Prognostic Significance of Transient Ischemic Dilation (TID) in Myocardial Perfusion Imaging: A Systematic Review and Meta-Analysis</vt:lpstr>
      <vt:lpstr>Background</vt:lpstr>
      <vt:lpstr>Objectives</vt:lpstr>
      <vt:lpstr>Methods</vt:lpstr>
      <vt:lpstr>PowerPoint Presentation</vt:lpstr>
      <vt:lpstr>Reports of Diagnostic Performance of TID</vt:lpstr>
      <vt:lpstr>ROC Curve for TID</vt:lpstr>
      <vt:lpstr>Subgroup Analyses</vt:lpstr>
      <vt:lpstr>TID and Prognosis CV death or MI</vt:lpstr>
      <vt:lpstr>Conclusions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</dc:title>
  <dc:creator>Alama, Mohamed</dc:creator>
  <cp:lastModifiedBy>DSL</cp:lastModifiedBy>
  <cp:revision>24</cp:revision>
  <dcterms:created xsi:type="dcterms:W3CDTF">2017-05-25T00:02:03Z</dcterms:created>
  <dcterms:modified xsi:type="dcterms:W3CDTF">2017-05-28T22:34:45Z</dcterms:modified>
</cp:coreProperties>
</file>